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259" r:id="rId5"/>
    <p:sldId id="26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61"/>
    <p:restoredTop sz="75070"/>
  </p:normalViewPr>
  <p:slideViewPr>
    <p:cSldViewPr snapToGrid="0">
      <p:cViewPr varScale="1">
        <p:scale>
          <a:sx n="86" d="100"/>
          <a:sy n="86" d="100"/>
        </p:scale>
        <p:origin x="182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All TE_c'!$B$1</c:f>
              <c:strCache>
                <c:ptCount val="1"/>
                <c:pt idx="0">
                  <c:v>Whole genom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All TE_c'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'All TE_c'!$B$2:$B$23</c:f>
              <c:numCache>
                <c:formatCode>General</c:formatCode>
                <c:ptCount val="22"/>
                <c:pt idx="0">
                  <c:v>3.3400866425189885E-3</c:v>
                </c:pt>
                <c:pt idx="1">
                  <c:v>6.4340346253581411E-3</c:v>
                </c:pt>
                <c:pt idx="2">
                  <c:v>1.4517690120195216E-2</c:v>
                </c:pt>
                <c:pt idx="3">
                  <c:v>3.1113337978104564E-2</c:v>
                </c:pt>
                <c:pt idx="4">
                  <c:v>5.9086323030580645E-2</c:v>
                </c:pt>
                <c:pt idx="5">
                  <c:v>7.8871508776521923E-2</c:v>
                </c:pt>
                <c:pt idx="6">
                  <c:v>7.3142957590159249E-2</c:v>
                </c:pt>
                <c:pt idx="7">
                  <c:v>6.9883705364111995E-2</c:v>
                </c:pt>
                <c:pt idx="8">
                  <c:v>6.9676486979029673E-2</c:v>
                </c:pt>
                <c:pt idx="9">
                  <c:v>6.1757921879738061E-2</c:v>
                </c:pt>
                <c:pt idx="10">
                  <c:v>6.057491661010396E-2</c:v>
                </c:pt>
                <c:pt idx="11">
                  <c:v>6.474515987892801E-2</c:v>
                </c:pt>
                <c:pt idx="12">
                  <c:v>7.3202621088031244E-2</c:v>
                </c:pt>
                <c:pt idx="13">
                  <c:v>8.0018159943509998E-2</c:v>
                </c:pt>
                <c:pt idx="14">
                  <c:v>7.9390944749034797E-2</c:v>
                </c:pt>
                <c:pt idx="15">
                  <c:v>6.8547371320376735E-2</c:v>
                </c:pt>
                <c:pt idx="16">
                  <c:v>5.1046720154244045E-2</c:v>
                </c:pt>
                <c:pt idx="17">
                  <c:v>3.1536114807111548E-2</c:v>
                </c:pt>
                <c:pt idx="18">
                  <c:v>1.5357683738980965E-2</c:v>
                </c:pt>
                <c:pt idx="19">
                  <c:v>5.6917693883914077E-3</c:v>
                </c:pt>
                <c:pt idx="20">
                  <c:v>1.7024412421469792E-3</c:v>
                </c:pt>
                <c:pt idx="21">
                  <c:v>3.6204409282186104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E1B9-4329-91BF-E870C4C6C6D1}"/>
            </c:ext>
          </c:extLst>
        </c:ser>
        <c:ser>
          <c:idx val="1"/>
          <c:order val="1"/>
          <c:tx>
            <c:strRef>
              <c:f>'All TE_c'!$C$1</c:f>
              <c:strCache>
                <c:ptCount val="1"/>
                <c:pt idx="0">
                  <c:v>DHS (Cell line specific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All TE_c'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'All TE_c'!$C$2:$C$23</c:f>
              <c:numCache>
                <c:formatCode>General</c:formatCode>
                <c:ptCount val="22"/>
                <c:pt idx="0">
                  <c:v>8.1793879423851896E-4</c:v>
                </c:pt>
                <c:pt idx="1">
                  <c:v>3.5311016239077523E-3</c:v>
                </c:pt>
                <c:pt idx="2">
                  <c:v>1.5421138730399393E-2</c:v>
                </c:pt>
                <c:pt idx="3">
                  <c:v>3.3854686190799184E-2</c:v>
                </c:pt>
                <c:pt idx="4">
                  <c:v>5.4343055500139646E-2</c:v>
                </c:pt>
                <c:pt idx="5">
                  <c:v>6.6033595339743845E-2</c:v>
                </c:pt>
                <c:pt idx="6">
                  <c:v>6.4617164744842998E-2</c:v>
                </c:pt>
                <c:pt idx="7">
                  <c:v>6.3839125403981969E-2</c:v>
                </c:pt>
                <c:pt idx="8">
                  <c:v>6.1764353828352554E-2</c:v>
                </c:pt>
                <c:pt idx="9">
                  <c:v>5.4442804133583371E-2</c:v>
                </c:pt>
                <c:pt idx="10">
                  <c:v>5.625822926225911E-2</c:v>
                </c:pt>
                <c:pt idx="11">
                  <c:v>6.8627059809280619E-2</c:v>
                </c:pt>
                <c:pt idx="12">
                  <c:v>8.0058253201931134E-2</c:v>
                </c:pt>
                <c:pt idx="13">
                  <c:v>9.384351434385349E-2</c:v>
                </c:pt>
                <c:pt idx="14">
                  <c:v>9.5060447671866902E-2</c:v>
                </c:pt>
                <c:pt idx="15">
                  <c:v>7.9619359214778751E-2</c:v>
                </c:pt>
                <c:pt idx="16">
                  <c:v>5.8213302477756051E-2</c:v>
                </c:pt>
                <c:pt idx="17">
                  <c:v>3.0642780193911343E-2</c:v>
                </c:pt>
                <c:pt idx="18">
                  <c:v>1.3685512508478635E-2</c:v>
                </c:pt>
                <c:pt idx="19">
                  <c:v>4.009895064437617E-3</c:v>
                </c:pt>
                <c:pt idx="20">
                  <c:v>1.037385787814707E-3</c:v>
                </c:pt>
                <c:pt idx="21">
                  <c:v>2.7929617364242108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1-E1B9-4329-91BF-E870C4C6C6D1}"/>
            </c:ext>
          </c:extLst>
        </c:ser>
        <c:ser>
          <c:idx val="2"/>
          <c:order val="2"/>
          <c:tx>
            <c:strRef>
              <c:f>'All TE_c'!$D$1</c:f>
              <c:strCache>
                <c:ptCount val="1"/>
                <c:pt idx="0">
                  <c:v>DHS (shared)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'All TE_c'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'All TE_c'!$D$2:$D$23</c:f>
              <c:numCache>
                <c:formatCode>General</c:formatCode>
                <c:ptCount val="22"/>
                <c:pt idx="1">
                  <c:v>6.1728395061728392E-3</c:v>
                </c:pt>
                <c:pt idx="2">
                  <c:v>0</c:v>
                </c:pt>
                <c:pt idx="3">
                  <c:v>0</c:v>
                </c:pt>
                <c:pt idx="4">
                  <c:v>2.4691358024691357E-2</c:v>
                </c:pt>
                <c:pt idx="5">
                  <c:v>3.0864197530864196E-2</c:v>
                </c:pt>
                <c:pt idx="6">
                  <c:v>2.4691358024691357E-2</c:v>
                </c:pt>
                <c:pt idx="7">
                  <c:v>3.7037037037037035E-2</c:v>
                </c:pt>
                <c:pt idx="8">
                  <c:v>1.2345679012345678E-2</c:v>
                </c:pt>
                <c:pt idx="9">
                  <c:v>3.0864197530864196E-2</c:v>
                </c:pt>
                <c:pt idx="10">
                  <c:v>6.7901234567901231E-2</c:v>
                </c:pt>
                <c:pt idx="11">
                  <c:v>0.11728395061728394</c:v>
                </c:pt>
                <c:pt idx="12">
                  <c:v>0.15432098765432098</c:v>
                </c:pt>
                <c:pt idx="13">
                  <c:v>0.12345679012345678</c:v>
                </c:pt>
                <c:pt idx="14">
                  <c:v>0.14814814814814814</c:v>
                </c:pt>
                <c:pt idx="15">
                  <c:v>0.10493827160493827</c:v>
                </c:pt>
                <c:pt idx="16">
                  <c:v>5.5555555555555552E-2</c:v>
                </c:pt>
                <c:pt idx="17">
                  <c:v>3.7037037037037035E-2</c:v>
                </c:pt>
                <c:pt idx="18">
                  <c:v>2.4691358024691357E-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E1B9-4329-91BF-E870C4C6C6D1}"/>
            </c:ext>
          </c:extLst>
        </c:ser>
        <c:ser>
          <c:idx val="3"/>
          <c:order val="3"/>
          <c:tx>
            <c:strRef>
              <c:f>'All TE_c'!$E$1</c:f>
              <c:strCache>
                <c:ptCount val="1"/>
                <c:pt idx="0">
                  <c:v>HA (Cell line specific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All TE_c'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'All TE_c'!$E$2:$E$23</c:f>
              <c:numCache>
                <c:formatCode>General</c:formatCode>
                <c:ptCount val="22"/>
                <c:pt idx="0">
                  <c:v>1.8617341411547566E-3</c:v>
                </c:pt>
                <c:pt idx="1">
                  <c:v>4.7987802431488985E-3</c:v>
                </c:pt>
                <c:pt idx="2">
                  <c:v>2.0398828391445651E-2</c:v>
                </c:pt>
                <c:pt idx="3">
                  <c:v>4.7249528547927619E-2</c:v>
                </c:pt>
                <c:pt idx="4">
                  <c:v>8.5399029009348801E-2</c:v>
                </c:pt>
                <c:pt idx="5">
                  <c:v>9.5783011675961968E-2</c:v>
                </c:pt>
                <c:pt idx="6">
                  <c:v>7.747863419331541E-2</c:v>
                </c:pt>
                <c:pt idx="7">
                  <c:v>7.1010712996027764E-2</c:v>
                </c:pt>
                <c:pt idx="8">
                  <c:v>6.5160694940416486E-2</c:v>
                </c:pt>
                <c:pt idx="9">
                  <c:v>5.328411507442924E-2</c:v>
                </c:pt>
                <c:pt idx="10">
                  <c:v>5.1173614733378808E-2</c:v>
                </c:pt>
                <c:pt idx="11">
                  <c:v>5.8764996188259838E-2</c:v>
                </c:pt>
                <c:pt idx="12">
                  <c:v>6.9983549331942382E-2</c:v>
                </c:pt>
                <c:pt idx="13">
                  <c:v>7.701320065802672E-2</c:v>
                </c:pt>
                <c:pt idx="14">
                  <c:v>7.4830477871845283E-2</c:v>
                </c:pt>
                <c:pt idx="15">
                  <c:v>6.1589696264494641E-2</c:v>
                </c:pt>
                <c:pt idx="16">
                  <c:v>4.4761866548970831E-2</c:v>
                </c:pt>
                <c:pt idx="17">
                  <c:v>2.4290815712394175E-2</c:v>
                </c:pt>
                <c:pt idx="18">
                  <c:v>1.0552501705252177E-2</c:v>
                </c:pt>
                <c:pt idx="19">
                  <c:v>3.4586526501625007E-3</c:v>
                </c:pt>
                <c:pt idx="20">
                  <c:v>9.8704008345704771E-4</c:v>
                </c:pt>
                <c:pt idx="21">
                  <c:v>1.6851903863900815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E1B9-4329-91BF-E870C4C6C6D1}"/>
            </c:ext>
          </c:extLst>
        </c:ser>
        <c:ser>
          <c:idx val="4"/>
          <c:order val="4"/>
          <c:tx>
            <c:strRef>
              <c:f>'All TE_c'!$F$1</c:f>
              <c:strCache>
                <c:ptCount val="1"/>
                <c:pt idx="0">
                  <c:v>HA (Shared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'All TE_c'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'All TE_c'!$F$2:$F$23</c:f>
              <c:numCache>
                <c:formatCode>General</c:formatCode>
                <c:ptCount val="22"/>
                <c:pt idx="0">
                  <c:v>1.384234299868862E-3</c:v>
                </c:pt>
                <c:pt idx="1">
                  <c:v>5.1362377968818297E-3</c:v>
                </c:pt>
                <c:pt idx="2">
                  <c:v>2.1419204429549761E-2</c:v>
                </c:pt>
                <c:pt idx="3">
                  <c:v>5.1872359026664726E-2</c:v>
                </c:pt>
                <c:pt idx="4">
                  <c:v>8.0285589392393997E-2</c:v>
                </c:pt>
                <c:pt idx="5">
                  <c:v>8.2653358589538109E-2</c:v>
                </c:pt>
                <c:pt idx="6">
                  <c:v>7.0887367040652779E-2</c:v>
                </c:pt>
                <c:pt idx="7">
                  <c:v>7.0304531545971147E-2</c:v>
                </c:pt>
                <c:pt idx="8">
                  <c:v>6.3601923357132453E-2</c:v>
                </c:pt>
                <c:pt idx="9">
                  <c:v>5.1835931808247124E-2</c:v>
                </c:pt>
                <c:pt idx="10">
                  <c:v>4.9941716450531838E-2</c:v>
                </c:pt>
                <c:pt idx="11">
                  <c:v>6.0359900917965906E-2</c:v>
                </c:pt>
                <c:pt idx="12">
                  <c:v>7.3182281800961674E-2</c:v>
                </c:pt>
                <c:pt idx="13">
                  <c:v>7.9520617805624361E-2</c:v>
                </c:pt>
                <c:pt idx="14">
                  <c:v>8.1378405944922044E-2</c:v>
                </c:pt>
                <c:pt idx="15">
                  <c:v>6.8155325659332647E-2</c:v>
                </c:pt>
                <c:pt idx="16">
                  <c:v>4.7756083345475736E-2</c:v>
                </c:pt>
                <c:pt idx="17">
                  <c:v>2.6081888387002768E-2</c:v>
                </c:pt>
                <c:pt idx="18">
                  <c:v>1.1073874398950896E-2</c:v>
                </c:pt>
                <c:pt idx="19">
                  <c:v>2.1492058866384961E-3</c:v>
                </c:pt>
                <c:pt idx="20">
                  <c:v>8.0139880518723594E-4</c:v>
                </c:pt>
                <c:pt idx="21">
                  <c:v>2.1856331050560979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4-E1B9-4329-91BF-E870C4C6C6D1}"/>
            </c:ext>
          </c:extLst>
        </c:ser>
        <c:ser>
          <c:idx val="5"/>
          <c:order val="5"/>
          <c:tx>
            <c:strRef>
              <c:f>'All TE_c'!$G$1</c:f>
              <c:strCache>
                <c:ptCount val="1"/>
                <c:pt idx="0">
                  <c:v>HR (Cell line specific)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'All TE_c'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'All TE_c'!$G$2:$G$23</c:f>
              <c:numCache>
                <c:formatCode>General</c:formatCode>
                <c:ptCount val="22"/>
                <c:pt idx="0">
                  <c:v>8.8449380854334022E-4</c:v>
                </c:pt>
                <c:pt idx="1">
                  <c:v>2.8564800046399674E-3</c:v>
                </c:pt>
                <c:pt idx="2">
                  <c:v>1.0990923063538556E-2</c:v>
                </c:pt>
                <c:pt idx="3">
                  <c:v>2.6926311515819389E-2</c:v>
                </c:pt>
                <c:pt idx="4">
                  <c:v>5.2852130035089755E-2</c:v>
                </c:pt>
                <c:pt idx="5">
                  <c:v>6.932401473189688E-2</c:v>
                </c:pt>
                <c:pt idx="6">
                  <c:v>6.5989038076733467E-2</c:v>
                </c:pt>
                <c:pt idx="7">
                  <c:v>6.5249543253197234E-2</c:v>
                </c:pt>
                <c:pt idx="8">
                  <c:v>6.3248557260099175E-2</c:v>
                </c:pt>
                <c:pt idx="9">
                  <c:v>5.6607603746773774E-2</c:v>
                </c:pt>
                <c:pt idx="10">
                  <c:v>6.0870573905982661E-2</c:v>
                </c:pt>
                <c:pt idx="11">
                  <c:v>6.9657512397413218E-2</c:v>
                </c:pt>
                <c:pt idx="12">
                  <c:v>8.2504422469042715E-2</c:v>
                </c:pt>
                <c:pt idx="13">
                  <c:v>9.2886349795551437E-2</c:v>
                </c:pt>
                <c:pt idx="14">
                  <c:v>9.2973349186555698E-2</c:v>
                </c:pt>
                <c:pt idx="15">
                  <c:v>7.7690456166806837E-2</c:v>
                </c:pt>
                <c:pt idx="16">
                  <c:v>5.5302612881709831E-2</c:v>
                </c:pt>
                <c:pt idx="17">
                  <c:v>3.2624771626598617E-2</c:v>
                </c:pt>
                <c:pt idx="18">
                  <c:v>1.4427399008206943E-2</c:v>
                </c:pt>
                <c:pt idx="19">
                  <c:v>4.5094684337209636E-3</c:v>
                </c:pt>
                <c:pt idx="20">
                  <c:v>1.290490966563234E-3</c:v>
                </c:pt>
                <c:pt idx="21">
                  <c:v>3.334976655163414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5-E1B9-4329-91BF-E870C4C6C6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30375647"/>
        <c:axId val="130993647"/>
      </c:lineChart>
      <c:catAx>
        <c:axId val="13037564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Sequence divergence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30993647"/>
        <c:crosses val="autoZero"/>
        <c:auto val="1"/>
        <c:lblAlgn val="ctr"/>
        <c:lblOffset val="100"/>
        <c:noMultiLvlLbl val="0"/>
      </c:catAx>
      <c:valAx>
        <c:axId val="130993647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Fraction in total T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303756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aseline="0">
          <a:solidFill>
            <a:sysClr val="windowText" lastClr="000000"/>
          </a:solidFill>
          <a:latin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INE_c!$B$1</c:f>
              <c:strCache>
                <c:ptCount val="1"/>
                <c:pt idx="0">
                  <c:v>Whole genom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S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SINE_c!$B$2:$B$23</c:f>
              <c:numCache>
                <c:formatCode>General</c:formatCode>
                <c:ptCount val="22"/>
                <c:pt idx="0">
                  <c:v>4.5987050858363769E-3</c:v>
                </c:pt>
                <c:pt idx="1">
                  <c:v>4.077241403136771E-3</c:v>
                </c:pt>
                <c:pt idx="2">
                  <c:v>2.0497409415928286E-2</c:v>
                </c:pt>
                <c:pt idx="3">
                  <c:v>5.4288364018358112E-2</c:v>
                </c:pt>
                <c:pt idx="4">
                  <c:v>0.11203695806373949</c:v>
                </c:pt>
                <c:pt idx="5">
                  <c:v>0.14650052524240503</c:v>
                </c:pt>
                <c:pt idx="6">
                  <c:v>0.11224802669721314</c:v>
                </c:pt>
                <c:pt idx="7">
                  <c:v>8.633030999558429E-2</c:v>
                </c:pt>
                <c:pt idx="8">
                  <c:v>7.1755238118887246E-2</c:v>
                </c:pt>
                <c:pt idx="9">
                  <c:v>4.4310377775066696E-2</c:v>
                </c:pt>
                <c:pt idx="10">
                  <c:v>2.8874297022690686E-2</c:v>
                </c:pt>
                <c:pt idx="11">
                  <c:v>2.9388743078190404E-2</c:v>
                </c:pt>
                <c:pt idx="12">
                  <c:v>4.0133270138700702E-2</c:v>
                </c:pt>
                <c:pt idx="13">
                  <c:v>5.2744486034382053E-2</c:v>
                </c:pt>
                <c:pt idx="14">
                  <c:v>5.9352931586771879E-2</c:v>
                </c:pt>
                <c:pt idx="15">
                  <c:v>5.3928845578732919E-2</c:v>
                </c:pt>
                <c:pt idx="16">
                  <c:v>3.9738123745599138E-2</c:v>
                </c:pt>
                <c:pt idx="17">
                  <c:v>2.3258035992870092E-2</c:v>
                </c:pt>
                <c:pt idx="18">
                  <c:v>1.0741827973125727E-2</c:v>
                </c:pt>
                <c:pt idx="19">
                  <c:v>3.830544816186751E-3</c:v>
                </c:pt>
                <c:pt idx="20">
                  <c:v>1.1325370665670523E-3</c:v>
                </c:pt>
                <c:pt idx="21">
                  <c:v>2.3320115002715283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55E9-4BFA-827E-F14D9A87FF33}"/>
            </c:ext>
          </c:extLst>
        </c:ser>
        <c:ser>
          <c:idx val="1"/>
          <c:order val="1"/>
          <c:tx>
            <c:strRef>
              <c:f>SINE_c!$C$1</c:f>
              <c:strCache>
                <c:ptCount val="1"/>
                <c:pt idx="0">
                  <c:v>DHS (Cell line specific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S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SINE_c!$C$2:$C$23</c:f>
              <c:numCache>
                <c:formatCode>General</c:formatCode>
                <c:ptCount val="22"/>
                <c:pt idx="0">
                  <c:v>1.4089042750181145E-3</c:v>
                </c:pt>
                <c:pt idx="1">
                  <c:v>4.7902745350615894E-3</c:v>
                </c:pt>
                <c:pt idx="2">
                  <c:v>2.4675952016745835E-2</c:v>
                </c:pt>
                <c:pt idx="3">
                  <c:v>5.534981080428307E-2</c:v>
                </c:pt>
                <c:pt idx="4">
                  <c:v>9.306819096691088E-2</c:v>
                </c:pt>
                <c:pt idx="5">
                  <c:v>0.10627163674422349</c:v>
                </c:pt>
                <c:pt idx="6">
                  <c:v>9.1135979389743174E-2</c:v>
                </c:pt>
                <c:pt idx="7">
                  <c:v>7.4792689799533046E-2</c:v>
                </c:pt>
                <c:pt idx="8">
                  <c:v>6.1186699943643827E-2</c:v>
                </c:pt>
                <c:pt idx="9">
                  <c:v>3.9489574108364865E-2</c:v>
                </c:pt>
                <c:pt idx="10">
                  <c:v>3.3048868851139203E-2</c:v>
                </c:pt>
                <c:pt idx="11">
                  <c:v>4.456162949843008E-2</c:v>
                </c:pt>
                <c:pt idx="12">
                  <c:v>6.3440946783672805E-2</c:v>
                </c:pt>
                <c:pt idx="13">
                  <c:v>7.8818130585299087E-2</c:v>
                </c:pt>
                <c:pt idx="14">
                  <c:v>8.1716447951050639E-2</c:v>
                </c:pt>
                <c:pt idx="15">
                  <c:v>6.6379518557282025E-2</c:v>
                </c:pt>
                <c:pt idx="16">
                  <c:v>4.5809516142017552E-2</c:v>
                </c:pt>
                <c:pt idx="17">
                  <c:v>2.1334836164560018E-2</c:v>
                </c:pt>
                <c:pt idx="18">
                  <c:v>9.178004991546574E-3</c:v>
                </c:pt>
                <c:pt idx="19">
                  <c:v>2.5762821028902667E-3</c:v>
                </c:pt>
                <c:pt idx="20">
                  <c:v>7.6483374929554784E-4</c:v>
                </c:pt>
                <c:pt idx="21">
                  <c:v>2.0127203928830206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1-55E9-4BFA-827E-F14D9A87FF33}"/>
            </c:ext>
          </c:extLst>
        </c:ser>
        <c:ser>
          <c:idx val="2"/>
          <c:order val="2"/>
          <c:tx>
            <c:strRef>
              <c:f>SINE_c!$D$1</c:f>
              <c:strCache>
                <c:ptCount val="1"/>
                <c:pt idx="0">
                  <c:v>DHS (shared)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S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SINE_c!$D$2:$D$23</c:f>
              <c:numCache>
                <c:formatCode>General</c:formatCode>
                <c:ptCount val="22"/>
                <c:pt idx="1">
                  <c:v>1.6129032258064516E-2</c:v>
                </c:pt>
                <c:pt idx="2">
                  <c:v>0</c:v>
                </c:pt>
                <c:pt idx="3">
                  <c:v>0</c:v>
                </c:pt>
                <c:pt idx="4">
                  <c:v>3.2258064516129031E-2</c:v>
                </c:pt>
                <c:pt idx="5">
                  <c:v>3.2258064516129031E-2</c:v>
                </c:pt>
                <c:pt idx="6">
                  <c:v>4.8387096774193547E-2</c:v>
                </c:pt>
                <c:pt idx="7">
                  <c:v>3.2258064516129031E-2</c:v>
                </c:pt>
                <c:pt idx="8">
                  <c:v>1.6129032258064516E-2</c:v>
                </c:pt>
                <c:pt idx="9">
                  <c:v>1.6129032258064516E-2</c:v>
                </c:pt>
                <c:pt idx="10">
                  <c:v>1.6129032258064516E-2</c:v>
                </c:pt>
                <c:pt idx="11">
                  <c:v>4.8387096774193547E-2</c:v>
                </c:pt>
                <c:pt idx="12">
                  <c:v>0.16129032258064516</c:v>
                </c:pt>
                <c:pt idx="13">
                  <c:v>0.12903225806451613</c:v>
                </c:pt>
                <c:pt idx="14">
                  <c:v>0.17741935483870969</c:v>
                </c:pt>
                <c:pt idx="15">
                  <c:v>0.12903225806451613</c:v>
                </c:pt>
                <c:pt idx="16">
                  <c:v>6.4516129032258063E-2</c:v>
                </c:pt>
                <c:pt idx="17">
                  <c:v>3.2258064516129031E-2</c:v>
                </c:pt>
                <c:pt idx="18">
                  <c:v>4.8387096774193547E-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55E9-4BFA-827E-F14D9A87FF33}"/>
            </c:ext>
          </c:extLst>
        </c:ser>
        <c:ser>
          <c:idx val="3"/>
          <c:order val="3"/>
          <c:tx>
            <c:strRef>
              <c:f>SINE_c!$E$1</c:f>
              <c:strCache>
                <c:ptCount val="1"/>
                <c:pt idx="0">
                  <c:v>HA (Cell line specific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S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SINE_c!$E$2:$E$23</c:f>
              <c:numCache>
                <c:formatCode>General</c:formatCode>
                <c:ptCount val="22"/>
                <c:pt idx="0">
                  <c:v>2.6090880884551376E-3</c:v>
                </c:pt>
                <c:pt idx="1">
                  <c:v>6.0784700871576456E-3</c:v>
                </c:pt>
                <c:pt idx="2">
                  <c:v>3.0759033086057597E-2</c:v>
                </c:pt>
                <c:pt idx="3">
                  <c:v>7.3689109525286997E-2</c:v>
                </c:pt>
                <c:pt idx="4">
                  <c:v>0.13653287450991453</c:v>
                </c:pt>
                <c:pt idx="5">
                  <c:v>0.14812568752996927</c:v>
                </c:pt>
                <c:pt idx="6">
                  <c:v>0.1061405240741263</c:v>
                </c:pt>
                <c:pt idx="7">
                  <c:v>8.3645953797986061E-2</c:v>
                </c:pt>
                <c:pt idx="8">
                  <c:v>6.4888725918822096E-2</c:v>
                </c:pt>
                <c:pt idx="9">
                  <c:v>3.7768312977745182E-2</c:v>
                </c:pt>
                <c:pt idx="10">
                  <c:v>2.6767833469664062E-2</c:v>
                </c:pt>
                <c:pt idx="11">
                  <c:v>3.3156573491665023E-2</c:v>
                </c:pt>
                <c:pt idx="12">
                  <c:v>4.42134657151722E-2</c:v>
                </c:pt>
                <c:pt idx="13">
                  <c:v>5.3930555947310527E-2</c:v>
                </c:pt>
                <c:pt idx="14">
                  <c:v>5.4452373565001551E-2</c:v>
                </c:pt>
                <c:pt idx="15">
                  <c:v>4.4467322934589458E-2</c:v>
                </c:pt>
                <c:pt idx="16">
                  <c:v>2.9800016923814628E-2</c:v>
                </c:pt>
                <c:pt idx="17">
                  <c:v>1.4667306010774829E-2</c:v>
                </c:pt>
                <c:pt idx="18">
                  <c:v>5.7964065100273602E-3</c:v>
                </c:pt>
                <c:pt idx="19">
                  <c:v>1.8898259667729106E-3</c:v>
                </c:pt>
                <c:pt idx="20">
                  <c:v>5.0771443883451325E-4</c:v>
                </c:pt>
                <c:pt idx="21">
                  <c:v>1.1282543085211407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55E9-4BFA-827E-F14D9A87FF33}"/>
            </c:ext>
          </c:extLst>
        </c:ser>
        <c:ser>
          <c:idx val="4"/>
          <c:order val="4"/>
          <c:tx>
            <c:strRef>
              <c:f>SINE_c!$F$1</c:f>
              <c:strCache>
                <c:ptCount val="1"/>
                <c:pt idx="0">
                  <c:v>HA (Shared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S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SINE_c!$F$2:$F$23</c:f>
              <c:numCache>
                <c:formatCode>General</c:formatCode>
                <c:ptCount val="22"/>
                <c:pt idx="0">
                  <c:v>1.7354877318970677E-3</c:v>
                </c:pt>
                <c:pt idx="1">
                  <c:v>7.2411729503291441E-3</c:v>
                </c:pt>
                <c:pt idx="2">
                  <c:v>3.267504488330341E-2</c:v>
                </c:pt>
                <c:pt idx="3">
                  <c:v>7.9293836026331541E-2</c:v>
                </c:pt>
                <c:pt idx="4">
                  <c:v>0.12357869539198085</c:v>
                </c:pt>
                <c:pt idx="5">
                  <c:v>0.12399760622381807</c:v>
                </c:pt>
                <c:pt idx="6">
                  <c:v>9.6050269299820468E-2</c:v>
                </c:pt>
                <c:pt idx="7">
                  <c:v>8.126870137642131E-2</c:v>
                </c:pt>
                <c:pt idx="8">
                  <c:v>6.3614602034709755E-2</c:v>
                </c:pt>
                <c:pt idx="9">
                  <c:v>4.0754039497307E-2</c:v>
                </c:pt>
                <c:pt idx="10">
                  <c:v>3.0460801915020947E-2</c:v>
                </c:pt>
                <c:pt idx="11">
                  <c:v>4.0215439856373429E-2</c:v>
                </c:pt>
                <c:pt idx="12">
                  <c:v>5.1406343506882106E-2</c:v>
                </c:pt>
                <c:pt idx="13">
                  <c:v>5.9964093357271098E-2</c:v>
                </c:pt>
                <c:pt idx="14">
                  <c:v>6.1280670257330937E-2</c:v>
                </c:pt>
                <c:pt idx="15">
                  <c:v>5.1226810293237585E-2</c:v>
                </c:pt>
                <c:pt idx="16">
                  <c:v>3.1897067624177142E-2</c:v>
                </c:pt>
                <c:pt idx="17">
                  <c:v>1.538001196888091E-2</c:v>
                </c:pt>
                <c:pt idx="18">
                  <c:v>6.0442848593656494E-3</c:v>
                </c:pt>
                <c:pt idx="19">
                  <c:v>1.2567324955116697E-3</c:v>
                </c:pt>
                <c:pt idx="20">
                  <c:v>4.7875523638539794E-4</c:v>
                </c:pt>
                <c:pt idx="21">
                  <c:v>1.7953321364452425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4-55E9-4BFA-827E-F14D9A87FF33}"/>
            </c:ext>
          </c:extLst>
        </c:ser>
        <c:ser>
          <c:idx val="5"/>
          <c:order val="5"/>
          <c:tx>
            <c:strRef>
              <c:f>SINE_c!$G$1</c:f>
              <c:strCache>
                <c:ptCount val="1"/>
                <c:pt idx="0">
                  <c:v>HR (Cell line specific)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S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SINE_c!$G$2:$G$23</c:f>
              <c:numCache>
                <c:formatCode>General</c:formatCode>
                <c:ptCount val="22"/>
                <c:pt idx="0">
                  <c:v>1.2672665061462425E-3</c:v>
                </c:pt>
                <c:pt idx="1">
                  <c:v>2.9780762894436701E-3</c:v>
                </c:pt>
                <c:pt idx="2">
                  <c:v>1.6537827905208465E-2</c:v>
                </c:pt>
                <c:pt idx="3">
                  <c:v>4.384742111265999E-2</c:v>
                </c:pt>
                <c:pt idx="4">
                  <c:v>9.2415409960714734E-2</c:v>
                </c:pt>
                <c:pt idx="5">
                  <c:v>0.11741224179444937</c:v>
                </c:pt>
                <c:pt idx="6">
                  <c:v>9.5837029527309589E-2</c:v>
                </c:pt>
                <c:pt idx="7">
                  <c:v>7.93942466100621E-2</c:v>
                </c:pt>
                <c:pt idx="8">
                  <c:v>6.2983145355468256E-2</c:v>
                </c:pt>
                <c:pt idx="9">
                  <c:v>4.0647573184640733E-2</c:v>
                </c:pt>
                <c:pt idx="10">
                  <c:v>3.5198327208211887E-2</c:v>
                </c:pt>
                <c:pt idx="11">
                  <c:v>4.23267013052845E-2</c:v>
                </c:pt>
                <c:pt idx="12">
                  <c:v>6.1367380560131794E-2</c:v>
                </c:pt>
                <c:pt idx="13">
                  <c:v>7.6479533645925732E-2</c:v>
                </c:pt>
                <c:pt idx="14">
                  <c:v>7.9204156634140155E-2</c:v>
                </c:pt>
                <c:pt idx="15">
                  <c:v>6.8907616271701944E-2</c:v>
                </c:pt>
                <c:pt idx="16">
                  <c:v>4.4544417691040429E-2</c:v>
                </c:pt>
                <c:pt idx="17">
                  <c:v>2.4616651881890762E-2</c:v>
                </c:pt>
                <c:pt idx="18">
                  <c:v>9.9163604105943475E-3</c:v>
                </c:pt>
                <c:pt idx="19">
                  <c:v>3.0414396147509823E-3</c:v>
                </c:pt>
                <c:pt idx="20">
                  <c:v>8.8708655430236978E-4</c:v>
                </c:pt>
                <c:pt idx="21">
                  <c:v>1.9008997592193639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5-55E9-4BFA-827E-F14D9A87FF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01312511"/>
        <c:axId val="293281391"/>
      </c:lineChart>
      <c:catAx>
        <c:axId val="30131251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Sequence divergence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293281391"/>
        <c:crosses val="autoZero"/>
        <c:auto val="1"/>
        <c:lblAlgn val="ctr"/>
        <c:lblOffset val="100"/>
        <c:noMultiLvlLbl val="0"/>
      </c:catAx>
      <c:valAx>
        <c:axId val="293281391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Fraction in total T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3013125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aseline="0">
          <a:solidFill>
            <a:sysClr val="windowText" lastClr="000000"/>
          </a:solidFill>
          <a:latin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LINE_c!$B$1</c:f>
              <c:strCache>
                <c:ptCount val="1"/>
                <c:pt idx="0">
                  <c:v>Whole genom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L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INE_c!$B$2:$B$23</c:f>
              <c:numCache>
                <c:formatCode>General</c:formatCode>
                <c:ptCount val="22"/>
                <c:pt idx="0">
                  <c:v>3.9756379934204238E-3</c:v>
                </c:pt>
                <c:pt idx="1">
                  <c:v>1.2324286735009685E-2</c:v>
                </c:pt>
                <c:pt idx="2">
                  <c:v>1.359154920608235E-2</c:v>
                </c:pt>
                <c:pt idx="3">
                  <c:v>1.6129895040100262E-2</c:v>
                </c:pt>
                <c:pt idx="4">
                  <c:v>2.2522247142928102E-2</c:v>
                </c:pt>
                <c:pt idx="5">
                  <c:v>2.6322124110209805E-2</c:v>
                </c:pt>
                <c:pt idx="6">
                  <c:v>3.30035903647296E-2</c:v>
                </c:pt>
                <c:pt idx="7">
                  <c:v>4.6001627699937722E-2</c:v>
                </c:pt>
                <c:pt idx="8">
                  <c:v>5.5343071513085915E-2</c:v>
                </c:pt>
                <c:pt idx="9">
                  <c:v>5.6865696924309407E-2</c:v>
                </c:pt>
                <c:pt idx="10">
                  <c:v>6.4527221944146201E-2</c:v>
                </c:pt>
                <c:pt idx="11">
                  <c:v>7.7594672148372873E-2</c:v>
                </c:pt>
                <c:pt idx="12">
                  <c:v>9.4062079303884452E-2</c:v>
                </c:pt>
                <c:pt idx="13">
                  <c:v>0.10541522268794648</c:v>
                </c:pt>
                <c:pt idx="14">
                  <c:v>0.10562600855625054</c:v>
                </c:pt>
                <c:pt idx="15">
                  <c:v>9.4990556028921605E-2</c:v>
                </c:pt>
                <c:pt idx="16">
                  <c:v>7.700307072343493E-2</c:v>
                </c:pt>
                <c:pt idx="17">
                  <c:v>5.233093508686798E-2</c:v>
                </c:pt>
                <c:pt idx="18">
                  <c:v>2.7633326837817149E-2</c:v>
                </c:pt>
                <c:pt idx="19">
                  <c:v>1.0710596734156353E-2</c:v>
                </c:pt>
                <c:pt idx="20">
                  <c:v>3.3088923616550574E-3</c:v>
                </c:pt>
                <c:pt idx="21">
                  <c:v>7.1769085673311197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E041-4851-9E4A-3F3AE233EC24}"/>
            </c:ext>
          </c:extLst>
        </c:ser>
        <c:ser>
          <c:idx val="1"/>
          <c:order val="1"/>
          <c:tx>
            <c:strRef>
              <c:f>LINE_c!$C$1</c:f>
              <c:strCache>
                <c:ptCount val="1"/>
                <c:pt idx="0">
                  <c:v>DHS (Cell line specific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L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INE_c!$C$2:$C$23</c:f>
              <c:numCache>
                <c:formatCode>General</c:formatCode>
                <c:ptCount val="22"/>
                <c:pt idx="0">
                  <c:v>7.3621438562909518E-5</c:v>
                </c:pt>
                <c:pt idx="1">
                  <c:v>1.6196716483840095E-3</c:v>
                </c:pt>
                <c:pt idx="2">
                  <c:v>2.2086431568872854E-3</c:v>
                </c:pt>
                <c:pt idx="3">
                  <c:v>5.1535006994036662E-3</c:v>
                </c:pt>
                <c:pt idx="4">
                  <c:v>6.1105794007214904E-3</c:v>
                </c:pt>
                <c:pt idx="5">
                  <c:v>1.0012515644555695E-2</c:v>
                </c:pt>
                <c:pt idx="6">
                  <c:v>1.8184495325038651E-2</c:v>
                </c:pt>
                <c:pt idx="7">
                  <c:v>3.033203268791872E-2</c:v>
                </c:pt>
                <c:pt idx="8">
                  <c:v>3.6810719281454761E-2</c:v>
                </c:pt>
                <c:pt idx="9">
                  <c:v>4.1154384156666418E-2</c:v>
                </c:pt>
                <c:pt idx="10">
                  <c:v>5.2344842818228668E-2</c:v>
                </c:pt>
                <c:pt idx="11">
                  <c:v>8.0836339542074656E-2</c:v>
                </c:pt>
                <c:pt idx="12">
                  <c:v>9.5707870131782377E-2</c:v>
                </c:pt>
                <c:pt idx="13">
                  <c:v>0.12633438857395274</c:v>
                </c:pt>
                <c:pt idx="14">
                  <c:v>0.14260472649635575</c:v>
                </c:pt>
                <c:pt idx="15">
                  <c:v>0.13288669660605168</c:v>
                </c:pt>
                <c:pt idx="16">
                  <c:v>0.1113892365456821</c:v>
                </c:pt>
                <c:pt idx="17">
                  <c:v>6.4492380181108741E-2</c:v>
                </c:pt>
                <c:pt idx="18">
                  <c:v>2.9816682617978357E-2</c:v>
                </c:pt>
                <c:pt idx="19">
                  <c:v>9.0554369432378715E-3</c:v>
                </c:pt>
                <c:pt idx="20">
                  <c:v>2.3558860340131046E-3</c:v>
                </c:pt>
                <c:pt idx="21">
                  <c:v>5.1535006994036668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1-E041-4851-9E4A-3F3AE233EC24}"/>
            </c:ext>
          </c:extLst>
        </c:ser>
        <c:ser>
          <c:idx val="2"/>
          <c:order val="2"/>
          <c:tx>
            <c:strRef>
              <c:f>LINE_c!$D$1</c:f>
              <c:strCache>
                <c:ptCount val="1"/>
                <c:pt idx="0">
                  <c:v>DHS (shared)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L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INE_c!$D$2:$D$23</c:f>
              <c:numCache>
                <c:formatCode>General</c:formatCode>
                <c:ptCount val="22"/>
                <c:pt idx="7">
                  <c:v>2.9411764705882353E-2</c:v>
                </c:pt>
                <c:pt idx="8">
                  <c:v>0</c:v>
                </c:pt>
                <c:pt idx="9">
                  <c:v>0</c:v>
                </c:pt>
                <c:pt idx="10">
                  <c:v>2.9411764705882353E-2</c:v>
                </c:pt>
                <c:pt idx="11">
                  <c:v>0.14705882352941177</c:v>
                </c:pt>
                <c:pt idx="12">
                  <c:v>8.8235294117647065E-2</c:v>
                </c:pt>
                <c:pt idx="13">
                  <c:v>0.14705882352941177</c:v>
                </c:pt>
                <c:pt idx="14">
                  <c:v>0.23529411764705882</c:v>
                </c:pt>
                <c:pt idx="15">
                  <c:v>0.11764705882352941</c:v>
                </c:pt>
                <c:pt idx="16">
                  <c:v>5.8823529411764705E-2</c:v>
                </c:pt>
                <c:pt idx="17">
                  <c:v>0.11764705882352941</c:v>
                </c:pt>
                <c:pt idx="18">
                  <c:v>2.9411764705882353E-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E041-4851-9E4A-3F3AE233EC24}"/>
            </c:ext>
          </c:extLst>
        </c:ser>
        <c:ser>
          <c:idx val="3"/>
          <c:order val="3"/>
          <c:tx>
            <c:strRef>
              <c:f>LINE_c!$E$1</c:f>
              <c:strCache>
                <c:ptCount val="1"/>
                <c:pt idx="0">
                  <c:v>HA (Cell line specific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L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INE_c!$E$2:$E$23</c:f>
              <c:numCache>
                <c:formatCode>General</c:formatCode>
                <c:ptCount val="22"/>
                <c:pt idx="0">
                  <c:v>1.0434328942219902E-3</c:v>
                </c:pt>
                <c:pt idx="1">
                  <c:v>2.9346550149993477E-3</c:v>
                </c:pt>
                <c:pt idx="2">
                  <c:v>4.597626190165645E-3</c:v>
                </c:pt>
                <c:pt idx="3">
                  <c:v>6.3584191991652534E-3</c:v>
                </c:pt>
                <c:pt idx="4">
                  <c:v>1.0727794443719837E-2</c:v>
                </c:pt>
                <c:pt idx="5">
                  <c:v>1.3988522238163558E-2</c:v>
                </c:pt>
                <c:pt idx="6">
                  <c:v>2.1683839833050736E-2</c:v>
                </c:pt>
                <c:pt idx="7">
                  <c:v>3.5574540237380985E-2</c:v>
                </c:pt>
                <c:pt idx="8">
                  <c:v>4.2845963218990479E-2</c:v>
                </c:pt>
                <c:pt idx="9">
                  <c:v>4.8389200469544799E-2</c:v>
                </c:pt>
                <c:pt idx="10">
                  <c:v>6.2508151819486116E-2</c:v>
                </c:pt>
                <c:pt idx="11">
                  <c:v>8.3344202425981478E-2</c:v>
                </c:pt>
                <c:pt idx="12">
                  <c:v>0.10727794443719839</c:v>
                </c:pt>
                <c:pt idx="13">
                  <c:v>0.12726620581713838</c:v>
                </c:pt>
                <c:pt idx="14">
                  <c:v>0.12811399504369375</c:v>
                </c:pt>
                <c:pt idx="15">
                  <c:v>0.11441893830703014</c:v>
                </c:pt>
                <c:pt idx="16">
                  <c:v>9.3941567757923575E-2</c:v>
                </c:pt>
                <c:pt idx="17">
                  <c:v>5.644319812182079E-2</c:v>
                </c:pt>
                <c:pt idx="18">
                  <c:v>2.6705360636494067E-2</c:v>
                </c:pt>
                <c:pt idx="19">
                  <c:v>8.8039650449980439E-3</c:v>
                </c:pt>
                <c:pt idx="20">
                  <c:v>2.6737967914438501E-3</c:v>
                </c:pt>
                <c:pt idx="21">
                  <c:v>3.586800573888092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E041-4851-9E4A-3F3AE233EC24}"/>
            </c:ext>
          </c:extLst>
        </c:ser>
        <c:ser>
          <c:idx val="4"/>
          <c:order val="4"/>
          <c:tx>
            <c:strRef>
              <c:f>LINE_c!$F$1</c:f>
              <c:strCache>
                <c:ptCount val="1"/>
                <c:pt idx="0">
                  <c:v>HA (Shared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L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INE_c!$F$2:$F$23</c:f>
              <c:numCache>
                <c:formatCode>General</c:formatCode>
                <c:ptCount val="22"/>
                <c:pt idx="0">
                  <c:v>5.9621404084066177E-4</c:v>
                </c:pt>
                <c:pt idx="1">
                  <c:v>1.341481591891489E-3</c:v>
                </c:pt>
                <c:pt idx="2">
                  <c:v>2.3848561633626471E-3</c:v>
                </c:pt>
                <c:pt idx="3">
                  <c:v>4.1734982858846323E-3</c:v>
                </c:pt>
                <c:pt idx="4">
                  <c:v>7.0055149798777762E-3</c:v>
                </c:pt>
                <c:pt idx="5">
                  <c:v>9.9865851840810847E-3</c:v>
                </c:pt>
                <c:pt idx="6">
                  <c:v>1.7141153674169025E-2</c:v>
                </c:pt>
                <c:pt idx="7">
                  <c:v>2.6978685348039946E-2</c:v>
                </c:pt>
                <c:pt idx="8">
                  <c:v>3.6965270532121029E-2</c:v>
                </c:pt>
                <c:pt idx="9">
                  <c:v>4.09897153077955E-2</c:v>
                </c:pt>
                <c:pt idx="10">
                  <c:v>5.589506632881204E-2</c:v>
                </c:pt>
                <c:pt idx="11">
                  <c:v>8.2426591146221487E-2</c:v>
                </c:pt>
                <c:pt idx="12">
                  <c:v>0.10895811596363095</c:v>
                </c:pt>
                <c:pt idx="13">
                  <c:v>0.1307199284543151</c:v>
                </c:pt>
                <c:pt idx="14">
                  <c:v>0.14473095841407066</c:v>
                </c:pt>
                <c:pt idx="15">
                  <c:v>0.12758980473990161</c:v>
                </c:pt>
                <c:pt idx="16">
                  <c:v>0.10463556416753615</c:v>
                </c:pt>
                <c:pt idx="17">
                  <c:v>6.1708153227008497E-2</c:v>
                </c:pt>
                <c:pt idx="18">
                  <c:v>2.8022059919511105E-2</c:v>
                </c:pt>
                <c:pt idx="19">
                  <c:v>5.2168728573557905E-3</c:v>
                </c:pt>
                <c:pt idx="20">
                  <c:v>2.0867491429423161E-3</c:v>
                </c:pt>
                <c:pt idx="21">
                  <c:v>4.4716053063049635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4-E041-4851-9E4A-3F3AE233EC24}"/>
            </c:ext>
          </c:extLst>
        </c:ser>
        <c:ser>
          <c:idx val="5"/>
          <c:order val="5"/>
          <c:tx>
            <c:strRef>
              <c:f>LINE_c!$G$1</c:f>
              <c:strCache>
                <c:ptCount val="1"/>
                <c:pt idx="0">
                  <c:v>HR (Cell line specific)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LINE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INE_c!$G$2:$G$23</c:f>
              <c:numCache>
                <c:formatCode>General</c:formatCode>
                <c:ptCount val="22"/>
                <c:pt idx="0">
                  <c:v>4.8239266763145202E-4</c:v>
                </c:pt>
                <c:pt idx="1">
                  <c:v>2.7013989387361312E-3</c:v>
                </c:pt>
                <c:pt idx="2">
                  <c:v>4.5827303424987942E-3</c:v>
                </c:pt>
                <c:pt idx="3">
                  <c:v>7.7182826821032323E-3</c:v>
                </c:pt>
                <c:pt idx="4">
                  <c:v>1.3699951760733237E-2</c:v>
                </c:pt>
                <c:pt idx="5">
                  <c:v>1.587071876507477E-2</c:v>
                </c:pt>
                <c:pt idx="6">
                  <c:v>2.6386878919440426E-2</c:v>
                </c:pt>
                <c:pt idx="7">
                  <c:v>3.7964302942595271E-2</c:v>
                </c:pt>
                <c:pt idx="8">
                  <c:v>4.7226242161119154E-2</c:v>
                </c:pt>
                <c:pt idx="9">
                  <c:v>4.8866377231066085E-2</c:v>
                </c:pt>
                <c:pt idx="10">
                  <c:v>5.9141341051616017E-2</c:v>
                </c:pt>
                <c:pt idx="11">
                  <c:v>8.1958514230583701E-2</c:v>
                </c:pt>
                <c:pt idx="12">
                  <c:v>9.8601061263868792E-2</c:v>
                </c:pt>
                <c:pt idx="13">
                  <c:v>0.12030873130728413</c:v>
                </c:pt>
                <c:pt idx="14">
                  <c:v>0.12807525325615052</c:v>
                </c:pt>
                <c:pt idx="15">
                  <c:v>0.11201157742402315</c:v>
                </c:pt>
                <c:pt idx="16">
                  <c:v>9.2474674384949343E-2</c:v>
                </c:pt>
                <c:pt idx="17">
                  <c:v>5.9816690786300052E-2</c:v>
                </c:pt>
                <c:pt idx="18">
                  <c:v>2.9232995658465991E-2</c:v>
                </c:pt>
                <c:pt idx="19">
                  <c:v>9.4066570188133143E-3</c:v>
                </c:pt>
                <c:pt idx="20">
                  <c:v>2.7496382054992764E-3</c:v>
                </c:pt>
                <c:pt idx="21">
                  <c:v>7.2358900144717795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5-E041-4851-9E4A-3F3AE233EC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97635199"/>
        <c:axId val="302037759"/>
      </c:lineChart>
      <c:catAx>
        <c:axId val="29763519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Sequence divergence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302037759"/>
        <c:crosses val="autoZero"/>
        <c:auto val="1"/>
        <c:lblAlgn val="ctr"/>
        <c:lblOffset val="100"/>
        <c:noMultiLvlLbl val="0"/>
      </c:catAx>
      <c:valAx>
        <c:axId val="302037759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Fraction in total T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297635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aseline="0">
          <a:solidFill>
            <a:sysClr val="windowText" lastClr="000000"/>
          </a:solidFill>
          <a:latin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LTR_c!$B$1</c:f>
              <c:strCache>
                <c:ptCount val="1"/>
                <c:pt idx="0">
                  <c:v>Whole genom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LTR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TR_c!$B$2:$B$23</c:f>
              <c:numCache>
                <c:formatCode>General</c:formatCode>
                <c:ptCount val="22"/>
                <c:pt idx="0">
                  <c:v>7.5875270673005633E-4</c:v>
                </c:pt>
                <c:pt idx="1">
                  <c:v>2.015770835309252E-3</c:v>
                </c:pt>
                <c:pt idx="2">
                  <c:v>8.3703247541734738E-3</c:v>
                </c:pt>
                <c:pt idx="3">
                  <c:v>2.1031342631616209E-2</c:v>
                </c:pt>
                <c:pt idx="4">
                  <c:v>3.6791491283026785E-2</c:v>
                </c:pt>
                <c:pt idx="5">
                  <c:v>5.7411397587754161E-2</c:v>
                </c:pt>
                <c:pt idx="6">
                  <c:v>7.6198542072704004E-2</c:v>
                </c:pt>
                <c:pt idx="7">
                  <c:v>8.1064978887171596E-2</c:v>
                </c:pt>
                <c:pt idx="8">
                  <c:v>8.5505285220218621E-2</c:v>
                </c:pt>
                <c:pt idx="9">
                  <c:v>8.9531483561916494E-2</c:v>
                </c:pt>
                <c:pt idx="10">
                  <c:v>9.2026818167852659E-2</c:v>
                </c:pt>
                <c:pt idx="11">
                  <c:v>9.0887353275527424E-2</c:v>
                </c:pt>
                <c:pt idx="12">
                  <c:v>8.6630055958012125E-2</c:v>
                </c:pt>
                <c:pt idx="13">
                  <c:v>8.1085016370623986E-2</c:v>
                </c:pt>
                <c:pt idx="14">
                  <c:v>7.3275741153117094E-2</c:v>
                </c:pt>
                <c:pt idx="15">
                  <c:v>5.6520397490238405E-2</c:v>
                </c:pt>
                <c:pt idx="16">
                  <c:v>3.5553174805669809E-2</c:v>
                </c:pt>
                <c:pt idx="17">
                  <c:v>1.7321736528465918E-2</c:v>
                </c:pt>
                <c:pt idx="18">
                  <c:v>6.0085733712531572E-3</c:v>
                </c:pt>
                <c:pt idx="19">
                  <c:v>1.6644469587775532E-3</c:v>
                </c:pt>
                <c:pt idx="20">
                  <c:v>3.0991307739678357E-4</c:v>
                </c:pt>
                <c:pt idx="21">
                  <c:v>3.7403302444439401E-5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6D4F-4DE7-97AD-98BE38D18429}"/>
            </c:ext>
          </c:extLst>
        </c:ser>
        <c:ser>
          <c:idx val="1"/>
          <c:order val="1"/>
          <c:tx>
            <c:strRef>
              <c:f>LTR_c!$C$1</c:f>
              <c:strCache>
                <c:ptCount val="1"/>
                <c:pt idx="0">
                  <c:v>DHS (Cell line specific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LTR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TR_c!$C$2:$C$23</c:f>
              <c:numCache>
                <c:formatCode>General</c:formatCode>
                <c:ptCount val="22"/>
                <c:pt idx="0">
                  <c:v>4.700720777185835E-4</c:v>
                </c:pt>
                <c:pt idx="1">
                  <c:v>3.4471952366029457E-3</c:v>
                </c:pt>
                <c:pt idx="2">
                  <c:v>1.7862738953306173E-2</c:v>
                </c:pt>
                <c:pt idx="3">
                  <c:v>3.4628643058602318E-2</c:v>
                </c:pt>
                <c:pt idx="4">
                  <c:v>4.4500156690692572E-2</c:v>
                </c:pt>
                <c:pt idx="5">
                  <c:v>6.3303039799435912E-2</c:v>
                </c:pt>
                <c:pt idx="6">
                  <c:v>7.4271388279536193E-2</c:v>
                </c:pt>
                <c:pt idx="7">
                  <c:v>9.1507364462550922E-2</c:v>
                </c:pt>
                <c:pt idx="8">
                  <c:v>9.0880601692259477E-2</c:v>
                </c:pt>
                <c:pt idx="9">
                  <c:v>9.5738013162018173E-2</c:v>
                </c:pt>
                <c:pt idx="10">
                  <c:v>9.9968661861485425E-2</c:v>
                </c:pt>
                <c:pt idx="11">
                  <c:v>9.260419931056095E-2</c:v>
                </c:pt>
                <c:pt idx="12">
                  <c:v>8.7590097148229393E-2</c:v>
                </c:pt>
                <c:pt idx="13">
                  <c:v>7.2704481353807582E-2</c:v>
                </c:pt>
                <c:pt idx="14">
                  <c:v>5.907239109996866E-2</c:v>
                </c:pt>
                <c:pt idx="15">
                  <c:v>3.9486054528361014E-2</c:v>
                </c:pt>
                <c:pt idx="16">
                  <c:v>2.1153243497336258E-2</c:v>
                </c:pt>
                <c:pt idx="17">
                  <c:v>7.3644625509244749E-3</c:v>
                </c:pt>
                <c:pt idx="18">
                  <c:v>2.5070510811657787E-3</c:v>
                </c:pt>
                <c:pt idx="19">
                  <c:v>7.8345346286430584E-4</c:v>
                </c:pt>
                <c:pt idx="20">
                  <c:v>0</c:v>
                </c:pt>
                <c:pt idx="21">
                  <c:v>1.5669069257286117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1-6D4F-4DE7-97AD-98BE38D18429}"/>
            </c:ext>
          </c:extLst>
        </c:ser>
        <c:ser>
          <c:idx val="2"/>
          <c:order val="2"/>
          <c:tx>
            <c:strRef>
              <c:f>LTR_c!$D$1</c:f>
              <c:strCache>
                <c:ptCount val="1"/>
                <c:pt idx="0">
                  <c:v>DHS (shared)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LTR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TR_c!$D$2:$D$23</c:f>
              <c:numCache>
                <c:formatCode>General</c:formatCode>
                <c:ptCount val="22"/>
                <c:pt idx="4">
                  <c:v>4.6511627906976744E-2</c:v>
                </c:pt>
                <c:pt idx="5">
                  <c:v>4.6511627906976744E-2</c:v>
                </c:pt>
                <c:pt idx="6">
                  <c:v>0</c:v>
                </c:pt>
                <c:pt idx="7">
                  <c:v>4.6511627906976744E-2</c:v>
                </c:pt>
                <c:pt idx="8">
                  <c:v>0</c:v>
                </c:pt>
                <c:pt idx="9">
                  <c:v>4.6511627906976744E-2</c:v>
                </c:pt>
                <c:pt idx="10">
                  <c:v>0.13953488372093023</c:v>
                </c:pt>
                <c:pt idx="11">
                  <c:v>9.3023255813953487E-2</c:v>
                </c:pt>
                <c:pt idx="12">
                  <c:v>0.18604651162790697</c:v>
                </c:pt>
                <c:pt idx="13">
                  <c:v>0.11627906976744186</c:v>
                </c:pt>
                <c:pt idx="14">
                  <c:v>0.11627906976744186</c:v>
                </c:pt>
                <c:pt idx="15">
                  <c:v>0.11627906976744186</c:v>
                </c:pt>
                <c:pt idx="16">
                  <c:v>4.6511627906976744E-2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6D4F-4DE7-97AD-98BE38D18429}"/>
            </c:ext>
          </c:extLst>
        </c:ser>
        <c:ser>
          <c:idx val="3"/>
          <c:order val="3"/>
          <c:tx>
            <c:strRef>
              <c:f>LTR_c!$E$1</c:f>
              <c:strCache>
                <c:ptCount val="1"/>
                <c:pt idx="0">
                  <c:v>HA (Cell line specific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LTR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TR_c!$E$2:$E$23</c:f>
              <c:numCache>
                <c:formatCode>General</c:formatCode>
                <c:ptCount val="22"/>
                <c:pt idx="0">
                  <c:v>5.683971201212581E-4</c:v>
                </c:pt>
                <c:pt idx="1">
                  <c:v>4.0735126942023497E-3</c:v>
                </c:pt>
                <c:pt idx="2">
                  <c:v>1.5915119363395226E-2</c:v>
                </c:pt>
                <c:pt idx="3">
                  <c:v>3.618794998105343E-2</c:v>
                </c:pt>
                <c:pt idx="4">
                  <c:v>4.4998105342932929E-2</c:v>
                </c:pt>
                <c:pt idx="5">
                  <c:v>6.5744600227358854E-2</c:v>
                </c:pt>
                <c:pt idx="6">
                  <c:v>7.985979537703676E-2</c:v>
                </c:pt>
                <c:pt idx="7">
                  <c:v>9.0754073512694197E-2</c:v>
                </c:pt>
                <c:pt idx="8">
                  <c:v>9.3501326259946949E-2</c:v>
                </c:pt>
                <c:pt idx="9">
                  <c:v>0.10126942023493747</c:v>
                </c:pt>
                <c:pt idx="10">
                  <c:v>9.8995831754452437E-2</c:v>
                </c:pt>
                <c:pt idx="11">
                  <c:v>8.9901477832512317E-2</c:v>
                </c:pt>
                <c:pt idx="12">
                  <c:v>8.7817355058734364E-2</c:v>
                </c:pt>
                <c:pt idx="13">
                  <c:v>6.830238726790451E-2</c:v>
                </c:pt>
                <c:pt idx="14">
                  <c:v>5.5039787798408485E-2</c:v>
                </c:pt>
                <c:pt idx="15">
                  <c:v>3.5524820007578631E-2</c:v>
                </c:pt>
                <c:pt idx="16">
                  <c:v>2.0841227737779463E-2</c:v>
                </c:pt>
                <c:pt idx="17">
                  <c:v>7.2944297082228118E-3</c:v>
                </c:pt>
                <c:pt idx="18">
                  <c:v>2.7472527472527475E-3</c:v>
                </c:pt>
                <c:pt idx="19">
                  <c:v>6.6312997347480103E-4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6D4F-4DE7-97AD-98BE38D18429}"/>
            </c:ext>
          </c:extLst>
        </c:ser>
        <c:ser>
          <c:idx val="4"/>
          <c:order val="4"/>
          <c:tx>
            <c:strRef>
              <c:f>LTR_c!$F$1</c:f>
              <c:strCache>
                <c:ptCount val="1"/>
                <c:pt idx="0">
                  <c:v>HA (Shared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LTR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TR_c!$F$2:$F$23</c:f>
              <c:numCache>
                <c:formatCode>General</c:formatCode>
                <c:ptCount val="22"/>
                <c:pt idx="0">
                  <c:v>3.2414910858995136E-3</c:v>
                </c:pt>
                <c:pt idx="1">
                  <c:v>6.4829821717990272E-3</c:v>
                </c:pt>
                <c:pt idx="2">
                  <c:v>1.4586709886547812E-2</c:v>
                </c:pt>
                <c:pt idx="3">
                  <c:v>3.8087520259319288E-2</c:v>
                </c:pt>
                <c:pt idx="4">
                  <c:v>5.4294975688816853E-2</c:v>
                </c:pt>
                <c:pt idx="5">
                  <c:v>4.2949756888168558E-2</c:v>
                </c:pt>
                <c:pt idx="6">
                  <c:v>7.4554294975688815E-2</c:v>
                </c:pt>
                <c:pt idx="7">
                  <c:v>0.11912479740680713</c:v>
                </c:pt>
                <c:pt idx="8">
                  <c:v>0.11750405186385737</c:v>
                </c:pt>
                <c:pt idx="9">
                  <c:v>0.10615883306320907</c:v>
                </c:pt>
                <c:pt idx="10">
                  <c:v>0.11021069692058347</c:v>
                </c:pt>
                <c:pt idx="11">
                  <c:v>9.8865478119935166E-2</c:v>
                </c:pt>
                <c:pt idx="12">
                  <c:v>8.3468395461912481E-2</c:v>
                </c:pt>
                <c:pt idx="13">
                  <c:v>4.6191247974068074E-2</c:v>
                </c:pt>
                <c:pt idx="14">
                  <c:v>3.7277147487844407E-2</c:v>
                </c:pt>
                <c:pt idx="15">
                  <c:v>3.2414910858995137E-2</c:v>
                </c:pt>
                <c:pt idx="16">
                  <c:v>1.1345218800648298E-2</c:v>
                </c:pt>
                <c:pt idx="17">
                  <c:v>3.2414910858995136E-3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4-6D4F-4DE7-97AD-98BE38D18429}"/>
            </c:ext>
          </c:extLst>
        </c:ser>
        <c:ser>
          <c:idx val="5"/>
          <c:order val="5"/>
          <c:tx>
            <c:strRef>
              <c:f>LTR_c!$G$1</c:f>
              <c:strCache>
                <c:ptCount val="1"/>
                <c:pt idx="0">
                  <c:v>HR (Cell line specific)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LTR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LTR_c!$G$2:$G$23</c:f>
              <c:numCache>
                <c:formatCode>General</c:formatCode>
                <c:ptCount val="22"/>
                <c:pt idx="0">
                  <c:v>6.0827250608272508E-4</c:v>
                </c:pt>
                <c:pt idx="1">
                  <c:v>3.1427412814274127E-3</c:v>
                </c:pt>
                <c:pt idx="2">
                  <c:v>1.2368207623682076E-2</c:v>
                </c:pt>
                <c:pt idx="3">
                  <c:v>2.8183292781832927E-2</c:v>
                </c:pt>
                <c:pt idx="4">
                  <c:v>3.7510137875101379E-2</c:v>
                </c:pt>
                <c:pt idx="5">
                  <c:v>6.0320356853203569E-2</c:v>
                </c:pt>
                <c:pt idx="6">
                  <c:v>7.2080291970802915E-2</c:v>
                </c:pt>
                <c:pt idx="7">
                  <c:v>8.1001622060016223E-2</c:v>
                </c:pt>
                <c:pt idx="8">
                  <c:v>8.9618815896188156E-2</c:v>
                </c:pt>
                <c:pt idx="9">
                  <c:v>9.1139497161394967E-2</c:v>
                </c:pt>
                <c:pt idx="10">
                  <c:v>0.10107461476074615</c:v>
                </c:pt>
                <c:pt idx="11">
                  <c:v>9.7120843471208432E-2</c:v>
                </c:pt>
                <c:pt idx="12">
                  <c:v>9.2964314679643154E-2</c:v>
                </c:pt>
                <c:pt idx="13">
                  <c:v>7.8872668288726688E-2</c:v>
                </c:pt>
                <c:pt idx="14">
                  <c:v>6.9140308191403085E-2</c:v>
                </c:pt>
                <c:pt idx="15">
                  <c:v>4.3694241686942414E-2</c:v>
                </c:pt>
                <c:pt idx="16">
                  <c:v>2.6358475263584754E-2</c:v>
                </c:pt>
                <c:pt idx="17">
                  <c:v>1.0239253852392539E-2</c:v>
                </c:pt>
                <c:pt idx="18">
                  <c:v>3.3454987834549877E-3</c:v>
                </c:pt>
                <c:pt idx="19">
                  <c:v>1.1151662611516627E-3</c:v>
                </c:pt>
                <c:pt idx="20">
                  <c:v>1.0137875101378751E-4</c:v>
                </c:pt>
                <c:pt idx="21">
                  <c:v>0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5-6D4F-4DE7-97AD-98BE38D184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01317311"/>
        <c:axId val="302025359"/>
      </c:lineChart>
      <c:catAx>
        <c:axId val="30131731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Sequence divergence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302025359"/>
        <c:crosses val="autoZero"/>
        <c:auto val="1"/>
        <c:lblAlgn val="ctr"/>
        <c:lblOffset val="100"/>
        <c:noMultiLvlLbl val="0"/>
      </c:catAx>
      <c:valAx>
        <c:axId val="302025359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Fraction in total T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3013173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aseline="0">
          <a:solidFill>
            <a:sysClr val="windowText" lastClr="000000"/>
          </a:solidFill>
          <a:latin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DNA_c!$B$1</c:f>
              <c:strCache>
                <c:ptCount val="1"/>
                <c:pt idx="0">
                  <c:v>Whole genom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DNA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DNA_c!$B$2:$B$23</c:f>
              <c:numCache>
                <c:formatCode>General</c:formatCode>
                <c:ptCount val="22"/>
                <c:pt idx="0">
                  <c:v>2.7850855662439616E-4</c:v>
                </c:pt>
                <c:pt idx="1">
                  <c:v>1.4366232740985038E-3</c:v>
                </c:pt>
                <c:pt idx="2">
                  <c:v>3.0595868055068557E-3</c:v>
                </c:pt>
                <c:pt idx="3">
                  <c:v>6.0871150721216946E-3</c:v>
                </c:pt>
                <c:pt idx="4">
                  <c:v>1.0757643456952395E-2</c:v>
                </c:pt>
                <c:pt idx="5">
                  <c:v>2.5899292107388092E-2</c:v>
                </c:pt>
                <c:pt idx="6">
                  <c:v>5.0365968258039177E-2</c:v>
                </c:pt>
                <c:pt idx="7">
                  <c:v>6.7841879271549846E-2</c:v>
                </c:pt>
                <c:pt idx="8">
                  <c:v>8.3895192621727274E-2</c:v>
                </c:pt>
                <c:pt idx="9">
                  <c:v>0.10068384870774033</c:v>
                </c:pt>
                <c:pt idx="10">
                  <c:v>0.11889309879840589</c:v>
                </c:pt>
                <c:pt idx="11">
                  <c:v>0.11662094985443419</c:v>
                </c:pt>
                <c:pt idx="12">
                  <c:v>0.11046571038716697</c:v>
                </c:pt>
                <c:pt idx="13">
                  <c:v>0.10002664866045399</c:v>
                </c:pt>
                <c:pt idx="14">
                  <c:v>8.0587152139807286E-2</c:v>
                </c:pt>
                <c:pt idx="15">
                  <c:v>5.7877684652174868E-2</c:v>
                </c:pt>
                <c:pt idx="16">
                  <c:v>3.4835609823537783E-2</c:v>
                </c:pt>
                <c:pt idx="17">
                  <c:v>1.8375553761167892E-2</c:v>
                </c:pt>
                <c:pt idx="18">
                  <c:v>8.0166383816849575E-3</c:v>
                </c:pt>
                <c:pt idx="19">
                  <c:v>2.9113160631312777E-3</c:v>
                </c:pt>
                <c:pt idx="20">
                  <c:v>8.7159152612670732E-4</c:v>
                </c:pt>
                <c:pt idx="21">
                  <c:v>2.1238782015961145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5BDE-4995-ABAD-0098622075A1}"/>
            </c:ext>
          </c:extLst>
        </c:ser>
        <c:ser>
          <c:idx val="1"/>
          <c:order val="1"/>
          <c:tx>
            <c:strRef>
              <c:f>DNA_c!$C$1</c:f>
              <c:strCache>
                <c:ptCount val="1"/>
                <c:pt idx="0">
                  <c:v>DHS (Cell line specific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DNA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DNA_c!$C$2:$C$23</c:f>
              <c:numCache>
                <c:formatCode>General</c:formatCode>
                <c:ptCount val="22"/>
                <c:pt idx="0">
                  <c:v>1.8971732119142499E-4</c:v>
                </c:pt>
                <c:pt idx="1">
                  <c:v>9.4858660595712385E-4</c:v>
                </c:pt>
                <c:pt idx="2">
                  <c:v>2.2766078542970974E-3</c:v>
                </c:pt>
                <c:pt idx="3">
                  <c:v>4.7429330297856197E-3</c:v>
                </c:pt>
                <c:pt idx="4">
                  <c:v>7.5886928476569908E-3</c:v>
                </c:pt>
                <c:pt idx="5">
                  <c:v>2.4473534433693798E-2</c:v>
                </c:pt>
                <c:pt idx="6">
                  <c:v>4.8188199582621896E-2</c:v>
                </c:pt>
                <c:pt idx="7">
                  <c:v>6.5262758489850123E-2</c:v>
                </c:pt>
                <c:pt idx="8">
                  <c:v>9.4099791310946687E-2</c:v>
                </c:pt>
                <c:pt idx="9">
                  <c:v>0.10927717700626068</c:v>
                </c:pt>
                <c:pt idx="10">
                  <c:v>0.12312654145323468</c:v>
                </c:pt>
                <c:pt idx="11">
                  <c:v>0.12160880288370328</c:v>
                </c:pt>
                <c:pt idx="12">
                  <c:v>0.10889774236387782</c:v>
                </c:pt>
                <c:pt idx="13">
                  <c:v>0.107190286473155</c:v>
                </c:pt>
                <c:pt idx="14">
                  <c:v>7.9112122936824125E-2</c:v>
                </c:pt>
                <c:pt idx="15">
                  <c:v>5.3690001897173212E-2</c:v>
                </c:pt>
                <c:pt idx="16">
                  <c:v>2.5042686397268071E-2</c:v>
                </c:pt>
                <c:pt idx="17">
                  <c:v>1.5367103016505406E-2</c:v>
                </c:pt>
                <c:pt idx="18">
                  <c:v>6.8298235628912922E-3</c:v>
                </c:pt>
                <c:pt idx="19">
                  <c:v>1.7074558907228231E-3</c:v>
                </c:pt>
                <c:pt idx="20">
                  <c:v>1.8971732119142478E-4</c:v>
                </c:pt>
                <c:pt idx="21">
                  <c:v>1.8971732119142478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1-5BDE-4995-ABAD-0098622075A1}"/>
            </c:ext>
          </c:extLst>
        </c:ser>
        <c:ser>
          <c:idx val="2"/>
          <c:order val="2"/>
          <c:tx>
            <c:strRef>
              <c:f>DNA_c!$D$1</c:f>
              <c:strCache>
                <c:ptCount val="1"/>
                <c:pt idx="0">
                  <c:v>DHS (shared)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DNA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DNA_c!$D$2:$D$23</c:f>
              <c:numCache>
                <c:formatCode>General</c:formatCode>
                <c:ptCount val="22"/>
                <c:pt idx="5">
                  <c:v>4.5454545454545456E-2</c:v>
                </c:pt>
                <c:pt idx="6">
                  <c:v>4.5454545454545456E-2</c:v>
                </c:pt>
                <c:pt idx="7">
                  <c:v>0</c:v>
                </c:pt>
                <c:pt idx="8">
                  <c:v>4.5454545454545456E-2</c:v>
                </c:pt>
                <c:pt idx="9">
                  <c:v>9.0909090909090912E-2</c:v>
                </c:pt>
                <c:pt idx="10">
                  <c:v>0.13636363636363635</c:v>
                </c:pt>
                <c:pt idx="11">
                  <c:v>0.31818181818181818</c:v>
                </c:pt>
                <c:pt idx="12">
                  <c:v>0.18181818181818182</c:v>
                </c:pt>
                <c:pt idx="13">
                  <c:v>9.0909090909090912E-2</c:v>
                </c:pt>
                <c:pt idx="14">
                  <c:v>0</c:v>
                </c:pt>
                <c:pt idx="15">
                  <c:v>0</c:v>
                </c:pt>
                <c:pt idx="16">
                  <c:v>4.5454545454545456E-2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5BDE-4995-ABAD-0098622075A1}"/>
            </c:ext>
          </c:extLst>
        </c:ser>
        <c:ser>
          <c:idx val="3"/>
          <c:order val="3"/>
          <c:tx>
            <c:strRef>
              <c:f>DNA_c!$E$1</c:f>
              <c:strCache>
                <c:ptCount val="1"/>
                <c:pt idx="0">
                  <c:v>HA (Cell line specific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DNA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DNA_c!$E$2:$E$23</c:f>
              <c:numCache>
                <c:formatCode>General</c:formatCode>
                <c:ptCount val="22"/>
                <c:pt idx="0">
                  <c:v>2.4340770791075051E-4</c:v>
                </c:pt>
                <c:pt idx="1">
                  <c:v>7.3022312373225155E-4</c:v>
                </c:pt>
                <c:pt idx="2">
                  <c:v>2.7586206896551722E-3</c:v>
                </c:pt>
                <c:pt idx="3">
                  <c:v>5.5983772819472614E-3</c:v>
                </c:pt>
                <c:pt idx="4">
                  <c:v>1.2251521298174441E-2</c:v>
                </c:pt>
                <c:pt idx="5">
                  <c:v>2.5152129817444219E-2</c:v>
                </c:pt>
                <c:pt idx="6">
                  <c:v>5.0385395537525357E-2</c:v>
                </c:pt>
                <c:pt idx="7">
                  <c:v>7.0263691683569982E-2</c:v>
                </c:pt>
                <c:pt idx="8">
                  <c:v>9.8498985801217034E-2</c:v>
                </c:pt>
                <c:pt idx="9">
                  <c:v>0.11375253549695741</c:v>
                </c:pt>
                <c:pt idx="10">
                  <c:v>0.12267748478701826</c:v>
                </c:pt>
                <c:pt idx="11">
                  <c:v>0.11805273833671399</c:v>
                </c:pt>
                <c:pt idx="12">
                  <c:v>0.10985801217038539</c:v>
                </c:pt>
                <c:pt idx="13">
                  <c:v>9.2413793103448272E-2</c:v>
                </c:pt>
                <c:pt idx="14">
                  <c:v>7.602434077079108E-2</c:v>
                </c:pt>
                <c:pt idx="15">
                  <c:v>5.0953346855983774E-2</c:v>
                </c:pt>
                <c:pt idx="16">
                  <c:v>2.9127789046653144E-2</c:v>
                </c:pt>
                <c:pt idx="17">
                  <c:v>1.4523326572008114E-2</c:v>
                </c:pt>
                <c:pt idx="18">
                  <c:v>4.5436105476673429E-3</c:v>
                </c:pt>
                <c:pt idx="19">
                  <c:v>1.6227180527383367E-3</c:v>
                </c:pt>
                <c:pt idx="20">
                  <c:v>4.0567951318458417E-4</c:v>
                </c:pt>
                <c:pt idx="21">
                  <c:v>1.6227180527383366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5BDE-4995-ABAD-0098622075A1}"/>
            </c:ext>
          </c:extLst>
        </c:ser>
        <c:ser>
          <c:idx val="4"/>
          <c:order val="4"/>
          <c:tx>
            <c:strRef>
              <c:f>DNA_c!$F$1</c:f>
              <c:strCache>
                <c:ptCount val="1"/>
                <c:pt idx="0">
                  <c:v>HA (Shared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DNA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DNA_c!$F$2:$F$23</c:f>
              <c:numCache>
                <c:formatCode>General</c:formatCode>
                <c:ptCount val="22"/>
                <c:pt idx="1">
                  <c:v>7.2202166064981946E-4</c:v>
                </c:pt>
                <c:pt idx="2">
                  <c:v>2.8880866425992778E-3</c:v>
                </c:pt>
                <c:pt idx="3">
                  <c:v>7.9422382671480145E-3</c:v>
                </c:pt>
                <c:pt idx="4">
                  <c:v>9.0252707581227436E-3</c:v>
                </c:pt>
                <c:pt idx="5">
                  <c:v>2.779783393501805E-2</c:v>
                </c:pt>
                <c:pt idx="6">
                  <c:v>4.8375451263537907E-2</c:v>
                </c:pt>
                <c:pt idx="7">
                  <c:v>8.7725631768953066E-2</c:v>
                </c:pt>
                <c:pt idx="8">
                  <c:v>0.10397111913357401</c:v>
                </c:pt>
                <c:pt idx="9">
                  <c:v>0.12093862815884476</c:v>
                </c:pt>
                <c:pt idx="10">
                  <c:v>0.1263537906137184</c:v>
                </c:pt>
                <c:pt idx="11">
                  <c:v>0.1111913357400722</c:v>
                </c:pt>
                <c:pt idx="12">
                  <c:v>0.11227436823104693</c:v>
                </c:pt>
                <c:pt idx="13">
                  <c:v>8.7364620938628165E-2</c:v>
                </c:pt>
                <c:pt idx="14">
                  <c:v>6.8592057761732855E-2</c:v>
                </c:pt>
                <c:pt idx="15">
                  <c:v>4.2599277978339352E-2</c:v>
                </c:pt>
                <c:pt idx="16">
                  <c:v>2.2021660649819495E-2</c:v>
                </c:pt>
                <c:pt idx="17">
                  <c:v>1.3718411552346571E-2</c:v>
                </c:pt>
                <c:pt idx="18">
                  <c:v>5.415162454873646E-3</c:v>
                </c:pt>
                <c:pt idx="19">
                  <c:v>1.0830324909747292E-3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4-5BDE-4995-ABAD-0098622075A1}"/>
            </c:ext>
          </c:extLst>
        </c:ser>
        <c:ser>
          <c:idx val="5"/>
          <c:order val="5"/>
          <c:tx>
            <c:strRef>
              <c:f>DNA_c!$G$1</c:f>
              <c:strCache>
                <c:ptCount val="1"/>
                <c:pt idx="0">
                  <c:v>HR (Cell line specific)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DNA_c!$A$2:$A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</c:numCache>
            </c:numRef>
          </c:cat>
          <c:val>
            <c:numRef>
              <c:f>DNA_c!$G$2:$G$23</c:f>
              <c:numCache>
                <c:formatCode>General</c:formatCode>
                <c:ptCount val="22"/>
                <c:pt idx="0">
                  <c:v>4.4536817102137769E-4</c:v>
                </c:pt>
                <c:pt idx="1">
                  <c:v>1.1876484560570072E-3</c:v>
                </c:pt>
                <c:pt idx="2">
                  <c:v>1.9299287410926365E-3</c:v>
                </c:pt>
                <c:pt idx="3">
                  <c:v>4.3052256532066504E-3</c:v>
                </c:pt>
                <c:pt idx="4">
                  <c:v>1.0540380047505939E-2</c:v>
                </c:pt>
                <c:pt idx="5">
                  <c:v>2.2119952494061759E-2</c:v>
                </c:pt>
                <c:pt idx="6">
                  <c:v>3.9489311163895487E-2</c:v>
                </c:pt>
                <c:pt idx="7">
                  <c:v>6.0570071258907364E-2</c:v>
                </c:pt>
                <c:pt idx="8">
                  <c:v>7.5861045130641333E-2</c:v>
                </c:pt>
                <c:pt idx="9">
                  <c:v>0.10495843230403801</c:v>
                </c:pt>
                <c:pt idx="10">
                  <c:v>0.12782066508313539</c:v>
                </c:pt>
                <c:pt idx="11">
                  <c:v>0.11965558194774346</c:v>
                </c:pt>
                <c:pt idx="12">
                  <c:v>0.11683491686460808</c:v>
                </c:pt>
                <c:pt idx="13">
                  <c:v>0.10525534441805226</c:v>
                </c:pt>
                <c:pt idx="14">
                  <c:v>8.4174584323040383E-2</c:v>
                </c:pt>
                <c:pt idx="15">
                  <c:v>6.2796912114014253E-2</c:v>
                </c:pt>
                <c:pt idx="16">
                  <c:v>3.3996437054631831E-2</c:v>
                </c:pt>
                <c:pt idx="17">
                  <c:v>1.9596199524940617E-2</c:v>
                </c:pt>
                <c:pt idx="18">
                  <c:v>6.3836104513064129E-3</c:v>
                </c:pt>
                <c:pt idx="19">
                  <c:v>1.3361045130641329E-3</c:v>
                </c:pt>
                <c:pt idx="20">
                  <c:v>4.4536817102137769E-4</c:v>
                </c:pt>
                <c:pt idx="21">
                  <c:v>2.9691211401425179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5-5BDE-4995-ABAD-0098622075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98368479"/>
        <c:axId val="303985551"/>
      </c:lineChart>
      <c:catAx>
        <c:axId val="2983684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Sequence divergence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303985551"/>
        <c:crosses val="autoZero"/>
        <c:auto val="1"/>
        <c:lblAlgn val="ctr"/>
        <c:lblOffset val="100"/>
        <c:noMultiLvlLbl val="0"/>
      </c:catAx>
      <c:valAx>
        <c:axId val="303985551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CA"/>
                  <a:t>Fraction in total T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2983684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aseline="0">
          <a:solidFill>
            <a:sysClr val="windowText" lastClr="000000"/>
          </a:solidFill>
          <a:latin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11DFCB-C623-4FB1-B986-FE6FE5C36290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2D2817-91E8-4C92-87C6-2EAA5E59A37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52290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b="1" kern="100" dirty="0">
                <a:latin typeface="Calibri"/>
                <a:ea typeface="Calibri" panose="020F0502020204030204" pitchFamily="34" charset="0"/>
                <a:cs typeface="Calibri"/>
              </a:rPr>
              <a:t>Fig.</a:t>
            </a:r>
            <a:r>
              <a:rPr lang="en-CA" sz="1200" b="1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 S1 Comparison of TE age profile of gene-neighboring regulatory regions to that of whole genome</a:t>
            </a:r>
            <a:r>
              <a:rPr lang="en-CA" b="1" kern="100" dirty="0">
                <a:latin typeface="Calibri"/>
                <a:ea typeface="Calibri" panose="020F0502020204030204" pitchFamily="34" charset="0"/>
                <a:cs typeface="Calibri"/>
              </a:rPr>
              <a:t> </a:t>
            </a:r>
            <a:endParaRPr lang="en-CA" kern="100" dirty="0">
              <a:latin typeface="Calibri"/>
              <a:ea typeface="Calibri" panose="020F0502020204030204" pitchFamily="34" charset="0"/>
              <a:cs typeface="Calibri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b="1" kern="100" dirty="0">
                <a:latin typeface="Calibri"/>
                <a:ea typeface="Calibri" panose="020F0502020204030204" pitchFamily="34" charset="0"/>
                <a:cs typeface="Calibri"/>
              </a:rPr>
              <a:t>a-e: l</a:t>
            </a:r>
            <a:r>
              <a:rPr lang="en-CA" kern="100" dirty="0">
                <a:latin typeface="Calibri"/>
                <a:ea typeface="Calibri" panose="020F0502020204030204" pitchFamily="34" charset="0"/>
                <a:cs typeface="Calibri"/>
              </a:rPr>
              <a:t>ine</a:t>
            </a:r>
            <a:r>
              <a:rPr lang="en-CA" sz="1200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 graph showing fraction of total TEs in different age classes (using sequence divergence as estimate of age) in cell line specific and shared gene-neighboring regulatory regions in comparison to the whole genome; </a:t>
            </a:r>
            <a:r>
              <a:rPr lang="en-CA" b="1" kern="100" dirty="0">
                <a:latin typeface="Calibri"/>
                <a:ea typeface="Calibri" panose="020F0502020204030204" pitchFamily="34" charset="0"/>
                <a:cs typeface="Calibri"/>
              </a:rPr>
              <a:t>f: </a:t>
            </a:r>
            <a:r>
              <a:rPr lang="en-CA" kern="100" dirty="0">
                <a:latin typeface="Calibri"/>
                <a:ea typeface="Calibri" panose="020F0502020204030204" pitchFamily="34" charset="0"/>
                <a:cs typeface="Calibri"/>
              </a:rPr>
              <a:t>a</a:t>
            </a:r>
            <a:r>
              <a:rPr lang="en-US" kern="100" dirty="0" err="1">
                <a:latin typeface="Calibri"/>
                <a:ea typeface="Calibri" panose="020F0502020204030204" pitchFamily="34" charset="0"/>
                <a:cs typeface="Calibri"/>
              </a:rPr>
              <a:t>verage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 sequence divergence of TEs in cell line specific and shared gene-neighboring regulatory regions compared to the whole genome</a:t>
            </a:r>
            <a:endParaRPr lang="en-CA" sz="1200" kern="100" dirty="0">
              <a:effectLst/>
              <a:latin typeface="Calibri"/>
              <a:ea typeface="Calibri" panose="020F0502020204030204" pitchFamily="34" charset="0"/>
              <a:cs typeface="Calibri"/>
            </a:endParaRP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2D2817-91E8-4C92-87C6-2EAA5E59A37E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479372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b="1" kern="100" dirty="0">
                <a:latin typeface="Calibri"/>
                <a:ea typeface="Calibri" panose="020F0502020204030204" pitchFamily="34" charset="0"/>
                <a:cs typeface="Calibri"/>
              </a:rPr>
              <a:t>Fig.</a:t>
            </a:r>
            <a:r>
              <a:rPr lang="en-CA" sz="1200" b="1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 S2 Correlation between cell lines based on TE density in regulatory region of all protein-coding genes</a:t>
            </a:r>
            <a:r>
              <a:rPr lang="en-CA" b="1" kern="100" dirty="0">
                <a:latin typeface="Calibri"/>
                <a:ea typeface="Calibri" panose="020F0502020204030204" pitchFamily="34" charset="0"/>
                <a:cs typeface="Calibri"/>
              </a:rPr>
              <a:t> </a:t>
            </a:r>
            <a:endParaRPr lang="en-US" dirty="0"/>
          </a:p>
          <a:p>
            <a:r>
              <a:rPr lang="en-CA" sz="1200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Regulatory region TE density was determined for every gene in every cell line and the heatmap here shows correlation between all possible pairs of cell lines based on this metric. </a:t>
            </a:r>
            <a:r>
              <a:rPr lang="en-CA" b="1" kern="100" dirty="0">
                <a:latin typeface="Calibri"/>
                <a:ea typeface="Calibri" panose="020F0502020204030204" pitchFamily="34" charset="0"/>
                <a:cs typeface="Calibri"/>
              </a:rPr>
              <a:t>a:</a:t>
            </a:r>
            <a:r>
              <a:rPr lang="en-CA" sz="1200" b="1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 </a:t>
            </a:r>
            <a:r>
              <a:rPr lang="en-CA" sz="1200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DHS; </a:t>
            </a:r>
            <a:r>
              <a:rPr lang="en-CA" b="1" kern="100" dirty="0">
                <a:latin typeface="Calibri"/>
                <a:ea typeface="Calibri" panose="020F0502020204030204" pitchFamily="34" charset="0"/>
                <a:cs typeface="Calibri"/>
              </a:rPr>
              <a:t>b:</a:t>
            </a:r>
            <a:r>
              <a:rPr lang="en-CA" sz="1200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 HA; </a:t>
            </a:r>
            <a:r>
              <a:rPr lang="en-CA" b="1" kern="100" dirty="0">
                <a:latin typeface="Calibri"/>
                <a:ea typeface="Calibri" panose="020F0502020204030204" pitchFamily="34" charset="0"/>
                <a:cs typeface="Calibri"/>
              </a:rPr>
              <a:t>c:</a:t>
            </a:r>
            <a:r>
              <a:rPr lang="en-CA" sz="1200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 </a:t>
            </a:r>
            <a:r>
              <a:rPr lang="en-CA" kern="100" dirty="0">
                <a:latin typeface="Calibri"/>
                <a:ea typeface="Calibri" panose="020F0502020204030204" pitchFamily="34" charset="0"/>
                <a:cs typeface="Calibri"/>
              </a:rPr>
              <a:t>HR. </a:t>
            </a:r>
            <a:r>
              <a:rPr lang="en-CA" i="1" kern="100" dirty="0" err="1">
                <a:latin typeface="Calibri"/>
                <a:ea typeface="Calibri" panose="020F0502020204030204" pitchFamily="34" charset="0"/>
                <a:cs typeface="Calibri"/>
              </a:rPr>
              <a:t>BL</a:t>
            </a:r>
            <a:r>
              <a:rPr lang="en-CA" sz="1200" i="1" kern="100" dirty="0" err="1">
                <a:effectLst/>
                <a:latin typeface="Calibri"/>
                <a:ea typeface="Calibri" panose="020F0502020204030204" pitchFamily="34" charset="0"/>
                <a:cs typeface="Calibri"/>
              </a:rPr>
              <a:t>.b</a:t>
            </a:r>
            <a:r>
              <a:rPr lang="en-CA" sz="1200" i="1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: Blood (B lineage), </a:t>
            </a:r>
            <a:r>
              <a:rPr lang="en-CA" sz="1200" i="1" kern="100" dirty="0" err="1">
                <a:effectLst/>
                <a:latin typeface="Calibri"/>
                <a:ea typeface="Calibri" panose="020F0502020204030204" pitchFamily="34" charset="0"/>
                <a:cs typeface="Calibri"/>
              </a:rPr>
              <a:t>BL.t</a:t>
            </a:r>
            <a:r>
              <a:rPr lang="en-CA" sz="1200" i="1" kern="100" dirty="0">
                <a:effectLst/>
                <a:latin typeface="Calibri"/>
                <a:ea typeface="Calibri" panose="020F0502020204030204" pitchFamily="34" charset="0"/>
                <a:cs typeface="Calibri"/>
              </a:rPr>
              <a:t>: Blood (T lineage), BRA: Brain, BRE: Breast, CE: Cervix, CO: Colon, LI: Liver, LU: Lung, PR: Prostate, SK: Skin</a:t>
            </a:r>
            <a:r>
              <a:rPr lang="en-CA" i="1" kern="100" dirty="0">
                <a:latin typeface="Calibri"/>
                <a:ea typeface="Calibri" panose="020F0502020204030204" pitchFamily="34" charset="0"/>
                <a:cs typeface="Calibri"/>
              </a:rPr>
              <a:t>.</a:t>
            </a:r>
            <a:endParaRPr lang="en-CA" sz="1200" kern="100" dirty="0">
              <a:effectLst/>
              <a:latin typeface="Calibri"/>
              <a:ea typeface="Calibri" panose="020F0502020204030204" pitchFamily="34" charset="0"/>
              <a:cs typeface="Calibri"/>
            </a:endParaRP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42D2817-91E8-4C92-87C6-2EAA5E59A37E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CA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44767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682674-7EB4-6EF5-5FD5-22A756875B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A5D15B-3DDC-36BE-8BD3-5EE6E91D18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3204C5-36B6-1E30-8AB7-25B2FC6B8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BD0781-0153-B511-2986-8A0F89EC7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152B3F-0563-669B-29AA-4AE9D71E5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0865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36A8B7-0564-F9F8-14B2-19FC1BB278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B3790B-4EA6-FBE3-A2E3-9888ED4378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E9807A-BF6C-2C8F-C99C-3CA632BB3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F83B4D-2DC2-708E-A9C8-3D0AB32FA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0B543E-FA35-CF69-0E7E-DB6CDDB76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44814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57DF33-8130-083F-D70C-F2E43E6445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98FB4D-5D43-E15D-2DA6-3931A61A2B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AF82BB-E7AE-6F37-03FB-89E00D833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2EEB74-1056-BE6C-AA61-F82B49A65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274A15-C1E6-8F62-B9A1-D729EAE9B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79700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2781DC-3B4A-C885-F671-695B2BA112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3A0593-4862-37BA-EF39-7A9CA1B435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6E6DB0-5C9E-4EEA-A021-392DC0127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C2AFA6-70FB-B008-0A03-A91FFB666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A99FBD-649F-2D2B-FC8F-EDA0399DD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81485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B11AB5-2C54-8F75-281D-7DBEFC8173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9CB177-7CB2-E5D3-726D-CA1B86842F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BA5F1D-99CE-A6FB-A527-F7610E2A0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0D6904-525C-D56C-83ED-3F9782737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98AD13-7D64-CE1B-9F51-67CA4F12B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07324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3FC8F1-541A-8483-2241-289B4A34BF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CB29AF-B31E-9E74-CE68-ECADE78F4C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D38FFA-43DA-15C1-3A9E-FF27DCCB1E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326E1C-0612-CA44-C9F2-5D6A60128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664B70-8EDD-197F-8C4D-B0571BA5A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43FE99-04F4-B95C-04A0-B019B6678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54491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3EF461-764C-D877-A230-3625B5123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0B2B01-39A6-7824-A812-4E6DE3FCFF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50E04C-B25A-89B1-ECC9-77EE389FA8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3C4891-6BB5-6653-30B7-44FFF8D063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1633C3C-2F0F-C29B-41D7-BD49B91818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4DBA006-288B-E463-9B8C-D8DEF4F26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11C8CF1-50AA-AEAD-6245-561EFB263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8FC21A-411E-18BB-BB1D-731FC36E8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58892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7FB336-4258-9414-90CD-B08627EAB9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74104D-E860-4720-5ACF-02F39FA3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CE10AD-DD81-6FC2-6104-16C4A2C60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0FDDD0-9C35-8EAC-DD88-0F4593C6A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7511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A8C96F-9B06-5DC3-0A02-2F338D1E8B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4EFE4F5-BFB8-E400-AE28-E5851C14B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CF8B47-A330-94D2-4B2E-E6C025EE3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7526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CCCB11-8AA1-8298-B3D3-418B504E62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AC8104-7DC9-8730-BF9E-F449BB2F9A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4A89A1-7460-CD0D-F956-50AC48C428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62E4C5-99AC-B39C-7BDA-72698B085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C0DB27-2A85-C11C-8A51-6075695D0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4B9414-70F3-B2A5-549E-6A79DD5BD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16387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75D6B-CD15-8C37-2E08-C51F81E89F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92403CA-5B0E-A114-2226-23BA42F9E4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889C1F-F3E0-883E-E646-10B68B3283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D75058-8077-1F90-C8E4-F9815D84A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72245A-B70C-A7F5-168F-AAE99C6B6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05E763-0505-9794-C114-002D0D41A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05048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73B84F-BB1E-5EDD-2718-3F4CF461C4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284AF9-3EDA-B8B7-4394-0E5571F91E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605414-49D0-1F67-EA6A-33DF2412F0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111A76E-F7C4-4D23-9D88-412A5E7886AB}" type="datetimeFigureOut">
              <a:rPr lang="en-CA" smtClean="0"/>
              <a:t>2024-07-0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D7CD78-71AA-A633-0642-E4C4DFD3F6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3C10AD-E220-70AF-F598-127A94A412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0B1C37-B694-436F-B7DD-7DF126F669C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82717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image" Target="../media/image3.png"/><Relationship Id="rId4" Type="http://schemas.openxmlformats.org/officeDocument/2006/relationships/chart" Target="../charts/chart2.xml"/><Relationship Id="rId9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0F06906-75BD-EB83-9D6B-090B4E572E2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96314499"/>
              </p:ext>
            </p:extLst>
          </p:nvPr>
        </p:nvGraphicFramePr>
        <p:xfrm>
          <a:off x="513381" y="334283"/>
          <a:ext cx="3695700" cy="2009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DAA1292-BCFD-DA8F-003F-EF42D1CF293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87655464"/>
              </p:ext>
            </p:extLst>
          </p:nvPr>
        </p:nvGraphicFramePr>
        <p:xfrm>
          <a:off x="489081" y="2506007"/>
          <a:ext cx="3429000" cy="1962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FD06C30E-0F00-7FA4-54C5-F260CD61AA6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217659518"/>
              </p:ext>
            </p:extLst>
          </p:nvPr>
        </p:nvGraphicFramePr>
        <p:xfrm>
          <a:off x="532968" y="4652073"/>
          <a:ext cx="3695699" cy="20288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404B2885-5BCF-AD83-DEB2-3C897AAA372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991372446"/>
              </p:ext>
            </p:extLst>
          </p:nvPr>
        </p:nvGraphicFramePr>
        <p:xfrm>
          <a:off x="4516984" y="397527"/>
          <a:ext cx="34290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FEB868D1-9A9A-AA19-416D-C4B0846BFD7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585153678"/>
              </p:ext>
            </p:extLst>
          </p:nvPr>
        </p:nvGraphicFramePr>
        <p:xfrm>
          <a:off x="4516936" y="2585641"/>
          <a:ext cx="3498553" cy="217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pic>
        <p:nvPicPr>
          <p:cNvPr id="9" name="Picture 8">
            <a:extLst>
              <a:ext uri="{FF2B5EF4-FFF2-40B4-BE49-F238E27FC236}">
                <a16:creationId xmlns:a16="http://schemas.microsoft.com/office/drawing/2014/main" id="{B636BD5B-3168-F7F4-66F9-E24CEB1634F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58514" y="5088686"/>
            <a:ext cx="3695699" cy="76816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3EAB72C-0A26-2B91-5F13-D361BF86E1AF}"/>
              </a:ext>
            </a:extLst>
          </p:cNvPr>
          <p:cNvSpPr txBox="1"/>
          <p:nvPr/>
        </p:nvSpPr>
        <p:spPr>
          <a:xfrm>
            <a:off x="172093" y="246418"/>
            <a:ext cx="308098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CA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819670D-7EAA-0F60-4A1F-5FE3B479A56D}"/>
              </a:ext>
            </a:extLst>
          </p:cNvPr>
          <p:cNvSpPr txBox="1"/>
          <p:nvPr/>
        </p:nvSpPr>
        <p:spPr>
          <a:xfrm>
            <a:off x="4030670" y="279756"/>
            <a:ext cx="314510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CA"/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40C5039-38F8-D099-095C-5F76F8D4E799}"/>
              </a:ext>
            </a:extLst>
          </p:cNvPr>
          <p:cNvSpPr txBox="1"/>
          <p:nvPr/>
        </p:nvSpPr>
        <p:spPr>
          <a:xfrm>
            <a:off x="200941" y="2369913"/>
            <a:ext cx="314510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CA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169A42E-445D-BF8B-6156-402C2844F93B}"/>
              </a:ext>
            </a:extLst>
          </p:cNvPr>
          <p:cNvSpPr txBox="1"/>
          <p:nvPr/>
        </p:nvSpPr>
        <p:spPr>
          <a:xfrm>
            <a:off x="4079779" y="2355447"/>
            <a:ext cx="306494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CA"/>
              <a:t>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3D3BC4-65D5-7CEF-2667-7818A64405E9}"/>
              </a:ext>
            </a:extLst>
          </p:cNvPr>
          <p:cNvSpPr txBox="1"/>
          <p:nvPr/>
        </p:nvSpPr>
        <p:spPr>
          <a:xfrm>
            <a:off x="154803" y="4586333"/>
            <a:ext cx="306494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CA"/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D5400E4-6C9F-1181-1CB1-6B76FD59E423}"/>
              </a:ext>
            </a:extLst>
          </p:cNvPr>
          <p:cNvSpPr txBox="1"/>
          <p:nvPr/>
        </p:nvSpPr>
        <p:spPr>
          <a:xfrm>
            <a:off x="2205852" y="372598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>
                <a:latin typeface="Arial" panose="020B0604020202020204" pitchFamily="34" charset="0"/>
                <a:cs typeface="Arial" panose="020B0604020202020204" pitchFamily="34" charset="0"/>
              </a:rPr>
              <a:t>All T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8E08DF6-E02C-E39C-E667-1E9D1DFFE7C8}"/>
              </a:ext>
            </a:extLst>
          </p:cNvPr>
          <p:cNvSpPr txBox="1"/>
          <p:nvPr/>
        </p:nvSpPr>
        <p:spPr>
          <a:xfrm>
            <a:off x="2365737" y="2328458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>
                <a:latin typeface="Arial" panose="020B0604020202020204" pitchFamily="34" charset="0"/>
                <a:cs typeface="Arial" panose="020B0604020202020204" pitchFamily="34" charset="0"/>
              </a:rPr>
              <a:t>SINE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5F12600-85D8-1EFD-DE5A-CA79C1AC33E3}"/>
              </a:ext>
            </a:extLst>
          </p:cNvPr>
          <p:cNvSpPr txBox="1"/>
          <p:nvPr/>
        </p:nvSpPr>
        <p:spPr>
          <a:xfrm>
            <a:off x="2267293" y="4529416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70C9F96-6B0D-D9A8-FF62-9B2BA394A5B7}"/>
              </a:ext>
            </a:extLst>
          </p:cNvPr>
          <p:cNvSpPr txBox="1"/>
          <p:nvPr/>
        </p:nvSpPr>
        <p:spPr>
          <a:xfrm>
            <a:off x="6380904" y="197051"/>
            <a:ext cx="6185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>
                <a:latin typeface="Arial" panose="020B0604020202020204" pitchFamily="34" charset="0"/>
                <a:cs typeface="Arial" panose="020B0604020202020204" pitchFamily="34" charset="0"/>
              </a:rPr>
              <a:t>LTR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0C36EB8-FC55-7256-FAF6-EBFB54F636D0}"/>
              </a:ext>
            </a:extLst>
          </p:cNvPr>
          <p:cNvSpPr txBox="1"/>
          <p:nvPr/>
        </p:nvSpPr>
        <p:spPr>
          <a:xfrm>
            <a:off x="6331680" y="2413740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>
                <a:latin typeface="Arial" panose="020B0604020202020204" pitchFamily="34" charset="0"/>
                <a:cs typeface="Arial" panose="020B0604020202020204" pitchFamily="34" charset="0"/>
              </a:rPr>
              <a:t>DNAs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500BF8D-5548-8E12-57DB-12095DCA6787}"/>
              </a:ext>
            </a:extLst>
          </p:cNvPr>
          <p:cNvCxnSpPr/>
          <p:nvPr/>
        </p:nvCxnSpPr>
        <p:spPr>
          <a:xfrm>
            <a:off x="8208635" y="431796"/>
            <a:ext cx="0" cy="622542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9" name="Picture 18">
            <a:extLst>
              <a:ext uri="{FF2B5EF4-FFF2-40B4-BE49-F238E27FC236}">
                <a16:creationId xmlns:a16="http://schemas.microsoft.com/office/drawing/2014/main" id="{5AABC7E2-78F0-7933-3094-01025F444EA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278208" y="284946"/>
            <a:ext cx="3741699" cy="319846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E1C5B50-D074-F8FE-19E2-89DDE60FD72B}"/>
              </a:ext>
            </a:extLst>
          </p:cNvPr>
          <p:cNvSpPr txBox="1"/>
          <p:nvPr/>
        </p:nvSpPr>
        <p:spPr>
          <a:xfrm>
            <a:off x="8436662" y="290989"/>
            <a:ext cx="253596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CA"/>
              <a:t>f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13DA42CF-5A86-77D4-FE48-B8D0E604957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74609" y="3429000"/>
            <a:ext cx="1463109" cy="105788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0B770F2-2A15-B56D-3F0C-88CFA13E65AC}"/>
              </a:ext>
            </a:extLst>
          </p:cNvPr>
          <p:cNvSpPr txBox="1"/>
          <p:nvPr/>
        </p:nvSpPr>
        <p:spPr>
          <a:xfrm>
            <a:off x="42334" y="21166"/>
            <a:ext cx="71120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>
                <a:latin typeface="Arial"/>
                <a:cs typeface="Arial"/>
              </a:rPr>
              <a:t>Fig. S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86FCD7A-75A6-9EE5-A60F-278138D83F12}"/>
              </a:ext>
            </a:extLst>
          </p:cNvPr>
          <p:cNvSpPr txBox="1"/>
          <p:nvPr/>
        </p:nvSpPr>
        <p:spPr>
          <a:xfrm>
            <a:off x="8347359" y="4503638"/>
            <a:ext cx="3741698" cy="23543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</a:t>
            </a:r>
            <a:r>
              <a:rPr lang="en-CA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1 Comparison of TE age profile of gene-neighboring regulatory regions to that of whole genome</a:t>
            </a:r>
            <a:endParaRPr lang="en-CA" sz="1200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-e: l</a:t>
            </a:r>
            <a:r>
              <a:rPr lang="en-CA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e</a:t>
            </a:r>
            <a:r>
              <a:rPr lang="en-CA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raph showing fraction of total TEs in different age classes (using sequence divergence as estimate of age) in cell line specific and shared gene-neighboring regulatory regions in comparison to the whole genome; </a:t>
            </a:r>
            <a:r>
              <a:rPr lang="en-CA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: </a:t>
            </a:r>
            <a:r>
              <a:rPr lang="en-CA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erage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equence divergence of TEs in cell line specific and shared gene-neighboring regulatory regions compared to the whole genome</a:t>
            </a:r>
            <a:endParaRPr lang="en-CA" sz="12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53134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ue and red squares with black text&#10;&#10;Description automatically generated">
            <a:extLst>
              <a:ext uri="{FF2B5EF4-FFF2-40B4-BE49-F238E27FC236}">
                <a16:creationId xmlns:a16="http://schemas.microsoft.com/office/drawing/2014/main" id="{69CE7528-242D-CF10-E69F-9872CA3297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275" y="487268"/>
            <a:ext cx="5177100" cy="3111065"/>
          </a:xfrm>
          <a:prstGeom prst="rect">
            <a:avLst/>
          </a:prstGeom>
        </p:spPr>
      </p:pic>
      <p:pic>
        <p:nvPicPr>
          <p:cNvPr id="7" name="Picture 6" descr="A blue and red rectangle with black text&#10;&#10;Description automatically generated">
            <a:extLst>
              <a:ext uri="{FF2B5EF4-FFF2-40B4-BE49-F238E27FC236}">
                <a16:creationId xmlns:a16="http://schemas.microsoft.com/office/drawing/2014/main" id="{4B1B6EB1-13D2-4DD0-5F97-E2A43A1CE4C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004" y="3607154"/>
            <a:ext cx="5177100" cy="3111065"/>
          </a:xfrm>
          <a:prstGeom prst="rect">
            <a:avLst/>
          </a:prstGeom>
        </p:spPr>
      </p:pic>
      <p:pic>
        <p:nvPicPr>
          <p:cNvPr id="9" name="Picture 8" descr="A close up of a chart&#10;&#10;Description automatically generated">
            <a:extLst>
              <a:ext uri="{FF2B5EF4-FFF2-40B4-BE49-F238E27FC236}">
                <a16:creationId xmlns:a16="http://schemas.microsoft.com/office/drawing/2014/main" id="{5D05C7AD-DF2C-BC3B-6221-4C4942FDCED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1747" y="478446"/>
            <a:ext cx="5177100" cy="311106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377F1F0-5EB3-EEB3-7520-0EE886F27534}"/>
              </a:ext>
            </a:extLst>
          </p:cNvPr>
          <p:cNvSpPr txBox="1"/>
          <p:nvPr/>
        </p:nvSpPr>
        <p:spPr>
          <a:xfrm>
            <a:off x="597589" y="566211"/>
            <a:ext cx="308098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>
                <a:solidFill>
                  <a:prstClr val="black"/>
                </a:solidFill>
                <a:latin typeface="Aptos" panose="02110004020202020204"/>
              </a:rPr>
              <a:t>a</a:t>
            </a:r>
            <a:endParaRPr kumimoji="0" lang="en-CA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7090256-9AB7-C8A6-2131-BCED7FFA19F2}"/>
              </a:ext>
            </a:extLst>
          </p:cNvPr>
          <p:cNvSpPr txBox="1"/>
          <p:nvPr/>
        </p:nvSpPr>
        <p:spPr>
          <a:xfrm>
            <a:off x="6275375" y="566211"/>
            <a:ext cx="306494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>
                <a:solidFill>
                  <a:prstClr val="black"/>
                </a:solidFill>
                <a:latin typeface="Aptos" panose="02110004020202020204"/>
              </a:rPr>
              <a:t>c</a:t>
            </a:r>
            <a:endParaRPr lang="en-CA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517C733-EE6C-A8CA-18DC-3769F26D5C6C}"/>
              </a:ext>
            </a:extLst>
          </p:cNvPr>
          <p:cNvSpPr txBox="1"/>
          <p:nvPr/>
        </p:nvSpPr>
        <p:spPr>
          <a:xfrm>
            <a:off x="715530" y="3413667"/>
            <a:ext cx="314510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>
                <a:solidFill>
                  <a:prstClr val="black"/>
                </a:solidFill>
                <a:latin typeface="Aptos" panose="02110004020202020204"/>
              </a:rPr>
              <a:t>b</a:t>
            </a:r>
            <a:endParaRPr lang="en-CA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EB8C82C-78A9-55BA-DB48-B15780CD41CF}"/>
              </a:ext>
            </a:extLst>
          </p:cNvPr>
          <p:cNvSpPr txBox="1"/>
          <p:nvPr/>
        </p:nvSpPr>
        <p:spPr>
          <a:xfrm>
            <a:off x="42334" y="21166"/>
            <a:ext cx="71120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>
                <a:latin typeface="Arial"/>
                <a:cs typeface="Arial"/>
              </a:rPr>
              <a:t>Fig. 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D6F5719-7DBB-71DC-2155-03F1A1326E0F}"/>
              </a:ext>
            </a:extLst>
          </p:cNvPr>
          <p:cNvSpPr txBox="1"/>
          <p:nvPr/>
        </p:nvSpPr>
        <p:spPr>
          <a:xfrm>
            <a:off x="6341068" y="4264297"/>
            <a:ext cx="544120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</a:t>
            </a:r>
            <a:r>
              <a:rPr lang="en-CA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2 Correlation between cell lines based on TE density in regulatory region of all protein-coding gen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CA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gulatory region TE density was determined for every gene in every cell line and the heatmap here shows correlation between all possible pairs of cell lines based on this metric. </a:t>
            </a:r>
            <a:r>
              <a:rPr lang="en-CA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:</a:t>
            </a:r>
            <a:r>
              <a:rPr lang="en-CA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CA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HS; </a:t>
            </a:r>
            <a:r>
              <a:rPr lang="en-CA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:</a:t>
            </a:r>
            <a:r>
              <a:rPr lang="en-CA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A; </a:t>
            </a:r>
            <a:r>
              <a:rPr lang="en-CA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:</a:t>
            </a:r>
            <a:r>
              <a:rPr lang="en-CA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CA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R. </a:t>
            </a:r>
            <a:r>
              <a:rPr lang="en-CA" sz="1200" i="1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</a:t>
            </a:r>
            <a:r>
              <a:rPr lang="en-CA" sz="1200" i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b</a:t>
            </a:r>
            <a:r>
              <a:rPr lang="en-CA" sz="12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Blood (B lineage), </a:t>
            </a:r>
            <a:r>
              <a:rPr lang="en-CA" sz="1200" i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.t</a:t>
            </a:r>
            <a:r>
              <a:rPr lang="en-CA" sz="12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Blood (T lineage), BRA: Brain, BRE: Breast, CE: Cervix, CO: Colon, LI: Liver, LU: Lung, PR: Prostate, SK: Skin</a:t>
            </a:r>
            <a:r>
              <a:rPr lang="en-CA" sz="1200" i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CA" sz="12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4678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55A06544200724B9C97B63900101B23" ma:contentTypeVersion="12" ma:contentTypeDescription="Create a new document." ma:contentTypeScope="" ma:versionID="5bf90d43afd1075b2b2eb71a4958eade">
  <xsd:schema xmlns:xsd="http://www.w3.org/2001/XMLSchema" xmlns:xs="http://www.w3.org/2001/XMLSchema" xmlns:p="http://schemas.microsoft.com/office/2006/metadata/properties" xmlns:ns2="e6f1d31b-4a05-4254-8d03-ce49713a9280" xmlns:ns3="b1260a2d-10cb-45bd-8a24-74316c69c942" targetNamespace="http://schemas.microsoft.com/office/2006/metadata/properties" ma:root="true" ma:fieldsID="9fb53ce021d448250d079687f2a0d8ea" ns2:_="" ns3:_="">
    <xsd:import namespace="e6f1d31b-4a05-4254-8d03-ce49713a9280"/>
    <xsd:import namespace="b1260a2d-10cb-45bd-8a24-74316c69c94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SearchProperties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6f1d31b-4a05-4254-8d03-ce49713a928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08d44918-0402-4173-a38e-4345c47fbb3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6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1260a2d-10cb-45bd-8a24-74316c69c942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e6f1d31b-4a05-4254-8d03-ce49713a9280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754F906-4E05-4538-8676-AA0A7D9E95C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6f1d31b-4a05-4254-8d03-ce49713a9280"/>
    <ds:schemaRef ds:uri="b1260a2d-10cb-45bd-8a24-74316c69c94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04D3F9E-177E-4985-863E-1844EAA673FD}">
  <ds:schemaRefs>
    <ds:schemaRef ds:uri="b1260a2d-10cb-45bd-8a24-74316c69c942"/>
    <ds:schemaRef ds:uri="e6f1d31b-4a05-4254-8d03-ce49713a9280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D9496C13-F10A-420E-A987-EC733800BDE1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34</Words>
  <Application>Microsoft Macintosh PowerPoint</Application>
  <PresentationFormat>Widescreen</PresentationFormat>
  <Paragraphs>3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sala Ali</dc:creator>
  <cp:lastModifiedBy>Ping Liang</cp:lastModifiedBy>
  <cp:revision>5</cp:revision>
  <dcterms:created xsi:type="dcterms:W3CDTF">2024-04-17T19:16:15Z</dcterms:created>
  <dcterms:modified xsi:type="dcterms:W3CDTF">2024-07-09T11:27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55A06544200724B9C97B63900101B23</vt:lpwstr>
  </property>
</Properties>
</file>